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iagrams/_rels/data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image" Target="../media/image2.png"/></Relationships>
</file>

<file path=ppt/diagrams/_rels/drawing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image" Target="../media/image2.png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6_3">
  <dgm:title val=""/>
  <dgm:desc val=""/>
  <dgm:catLst>
    <dgm:cat type="accent6" pri="11300"/>
  </dgm:catLst>
  <dgm:styleLbl name="node0">
    <dgm:fillClrLst meth="repeat"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6">
        <a:shade val="80000"/>
      </a:schemeClr>
      <a:schemeClr val="accent6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6">
        <a:shade val="80000"/>
      </a:schemeClr>
      <a:schemeClr val="accent6">
        <a:tint val="70000"/>
      </a:schemeClr>
    </dgm:fillClrLst>
    <dgm:linClrLst>
      <a:schemeClr val="accent6">
        <a:shade val="80000"/>
      </a:schemeClr>
      <a:schemeClr val="accent6">
        <a:tint val="70000"/>
      </a:schemeClr>
    </dgm:linClrLst>
    <dgm:effectClrLst/>
    <dgm:txLinClrLst/>
    <dgm:txFillClrLst/>
    <dgm:txEffectClrLst/>
  </dgm:styleLbl>
  <dgm:styleLbl name="lnNode1">
    <dgm:fillClrLst>
      <a:schemeClr val="accent6">
        <a:shade val="80000"/>
      </a:schemeClr>
      <a:schemeClr val="accent6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6">
        <a:shade val="80000"/>
        <a:alpha val="50000"/>
      </a:schemeClr>
      <a:schemeClr val="accent6">
        <a:tint val="70000"/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6">
        <a:tint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6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6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6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6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6">
        <a:shade val="90000"/>
      </a:schemeClr>
      <a:schemeClr val="accent6">
        <a:tint val="70000"/>
      </a:schemeClr>
    </dgm:fillClrLst>
    <dgm:linClrLst>
      <a:schemeClr val="accent6">
        <a:shade val="90000"/>
      </a:schemeClr>
      <a:schemeClr val="accent6">
        <a:tint val="70000"/>
      </a:schemeClr>
    </dgm:linClrLst>
    <dgm:effectClrLst/>
    <dgm:txLinClrLst/>
    <dgm:txFillClrLst/>
    <dgm:txEffectClrLst/>
  </dgm:styleLbl>
  <dgm:styleLbl name="fgSibTrans2D1">
    <dgm:fillClrLst>
      <a:schemeClr val="accent6">
        <a:shade val="90000"/>
      </a:schemeClr>
      <a:schemeClr val="accent6">
        <a:tint val="70000"/>
      </a:schemeClr>
    </dgm:fillClrLst>
    <dgm:linClrLst>
      <a:schemeClr val="accent6">
        <a:shade val="90000"/>
      </a:schemeClr>
      <a:schemeClr val="accent6">
        <a:tint val="70000"/>
      </a:schemeClr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6">
        <a:shade val="90000"/>
      </a:schemeClr>
      <a:schemeClr val="accent6">
        <a:tint val="70000"/>
      </a:schemeClr>
    </dgm:fillClrLst>
    <dgm:linClrLst>
      <a:schemeClr val="accent6">
        <a:shade val="90000"/>
      </a:schemeClr>
      <a:schemeClr val="accent6">
        <a:tint val="70000"/>
      </a:schemeClr>
    </dgm:linClrLst>
    <dgm:effectClrLst/>
    <dgm:txLinClrLst/>
    <dgm:txFillClrLst meth="repeat">
      <a:schemeClr val="lt1"/>
    </dgm:txFillClrLst>
    <dgm:txEffectClrLst/>
  </dgm:styleLbl>
  <dgm:styleLbl name="sibTrans1D1">
    <dgm:fillClrLst>
      <a:schemeClr val="accent6">
        <a:shade val="90000"/>
      </a:schemeClr>
      <a:schemeClr val="accent6">
        <a:tint val="70000"/>
      </a:schemeClr>
    </dgm:fillClrLst>
    <dgm:linClrLst>
      <a:schemeClr val="accent6">
        <a:shade val="90000"/>
      </a:schemeClr>
      <a:schemeClr val="accent6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6"/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6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6">
        <a:tint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6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6">
        <a:tint val="60000"/>
      </a:schemeClr>
    </dgm:fillClrLst>
    <dgm:linClrLst meth="repeat">
      <a:schemeClr val="accent6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6">
        <a:tint val="90000"/>
      </a:schemeClr>
    </dgm:fillClrLst>
    <dgm:linClrLst meth="repeat">
      <a:schemeClr val="accent6">
        <a:tint val="90000"/>
      </a:schemeClr>
    </dgm:linClrLst>
    <dgm:effectClrLst/>
    <dgm:txLinClrLst/>
    <dgm:txFillClrLst/>
    <dgm:txEffectClrLst/>
  </dgm:styleLbl>
  <dgm:styleLbl name="parChTrans2D3">
    <dgm:fillClrLst meth="repeat">
      <a:schemeClr val="accent6">
        <a:tint val="70000"/>
      </a:schemeClr>
    </dgm:fillClrLst>
    <dgm:linClrLst meth="repeat">
      <a:schemeClr val="accent6">
        <a:tint val="70000"/>
      </a:schemeClr>
    </dgm:linClrLst>
    <dgm:effectClrLst/>
    <dgm:txLinClrLst/>
    <dgm:txFillClrLst/>
    <dgm:txEffectClrLst/>
  </dgm:styleLbl>
  <dgm:styleLbl name="parChTrans2D4">
    <dgm:fillClrLst meth="repeat">
      <a:schemeClr val="accent6">
        <a:tint val="50000"/>
      </a:schemeClr>
    </dgm:fillClrLst>
    <dgm:linClrLst meth="repeat">
      <a:schemeClr val="accent6">
        <a:tint val="50000"/>
      </a:schemeClr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6">
        <a:shade val="80000"/>
      </a:schemeClr>
    </dgm:fillClrLst>
    <dgm:linClrLst meth="repeat">
      <a:schemeClr val="accent6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9000"/>
      </a:schemeClr>
    </dgm:fillClrLst>
    <dgm:linClrLst meth="repeat">
      <a:schemeClr val="accent6">
        <a:tint val="99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80000"/>
      </a:schemeClr>
    </dgm:fillClrLst>
    <dgm:linClrLst meth="repeat">
      <a:schemeClr val="accent6">
        <a:tint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70000"/>
      </a:schemeClr>
    </dgm:fillClrLst>
    <dgm:linClrLst meth="repeat">
      <a:schemeClr val="accent6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6">
        <a:shade val="80000"/>
      </a:schemeClr>
      <a:schemeClr val="accent6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6">
        <a:shade val="80000"/>
      </a:schemeClr>
      <a:schemeClr val="accent6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6">
        <a:shade val="80000"/>
      </a:schemeClr>
      <a:schemeClr val="accent6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6">
        <a:shade val="80000"/>
      </a:schemeClr>
      <a:schemeClr val="accent6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6">
        <a:shade val="80000"/>
      </a:schemeClr>
      <a:schemeClr val="accent6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6">
        <a:alpha val="90000"/>
        <a:tint val="40000"/>
      </a:schemeClr>
    </dgm:fillClrLst>
    <dgm:linClrLst meth="repeat">
      <a:schemeClr val="accent6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6">
        <a:alpha val="90000"/>
        <a:tint val="40000"/>
      </a:schemeClr>
    </dgm:fillClrLst>
    <dgm:linClrLst meth="repeat">
      <a:schemeClr val="accent6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6">
        <a:alpha val="90000"/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6">
        <a:tint val="99000"/>
      </a:schemeClr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6">
        <a:tint val="80000"/>
      </a:schemeClr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6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6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6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6">
        <a:tint val="50000"/>
        <a:alpha val="40000"/>
      </a:schemeClr>
    </dgm:fillClrLst>
    <dgm:linClrLst meth="repeat">
      <a:schemeClr val="accent6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6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1E4C0D43-5484-164E-9448-9A65D67B2AD1}" type="doc">
      <dgm:prSet loTypeId="urn:microsoft.com/office/officeart/2005/8/layout/bList2" loCatId="" qsTypeId="urn:microsoft.com/office/officeart/2005/8/quickstyle/simple2" qsCatId="simple" csTypeId="urn:microsoft.com/office/officeart/2005/8/colors/accent6_3" csCatId="accent6" phldr="1"/>
      <dgm:spPr/>
      <dgm:t>
        <a:bodyPr/>
        <a:lstStyle/>
        <a:p>
          <a:endParaRPr lang="es-ES"/>
        </a:p>
      </dgm:t>
    </dgm:pt>
    <dgm:pt modelId="{FB58902A-810F-F546-A44E-289395005808}">
      <dgm:prSet phldrT="[Texto]"/>
      <dgm:spPr>
        <a:solidFill>
          <a:schemeClr val="accent6">
            <a:lumMod val="75000"/>
          </a:schemeClr>
        </a:solidFill>
      </dgm:spPr>
      <dgm:t>
        <a:bodyPr/>
        <a:lstStyle/>
        <a:p>
          <a:r>
            <a:rPr lang="es-ES" b="1" dirty="0"/>
            <a:t>Descriptive study</a:t>
          </a:r>
        </a:p>
      </dgm:t>
    </dgm:pt>
    <dgm:pt modelId="{736097F9-C76F-5F4F-88B6-B19C430C34F7}" type="parTrans" cxnId="{684B0662-E2FC-184A-9641-A2103A6524B2}">
      <dgm:prSet/>
      <dgm:spPr/>
      <dgm:t>
        <a:bodyPr/>
        <a:lstStyle/>
        <a:p>
          <a:endParaRPr lang="es-ES"/>
        </a:p>
      </dgm:t>
    </dgm:pt>
    <dgm:pt modelId="{0B3B1669-BB90-7E41-88F5-684ECF2869E8}" type="sibTrans" cxnId="{684B0662-E2FC-184A-9641-A2103A6524B2}">
      <dgm:prSet/>
      <dgm:spPr/>
      <dgm:t>
        <a:bodyPr/>
        <a:lstStyle/>
        <a:p>
          <a:endParaRPr lang="es-ES"/>
        </a:p>
      </dgm:t>
    </dgm:pt>
    <dgm:pt modelId="{F40605C9-494D-2A45-B265-19A6B81688B0}">
      <dgm:prSet phldrT="[Texto]"/>
      <dgm:spPr>
        <a:solidFill>
          <a:schemeClr val="accent6">
            <a:lumMod val="75000"/>
          </a:schemeClr>
        </a:solidFill>
      </dgm:spPr>
      <dgm:t>
        <a:bodyPr/>
        <a:lstStyle/>
        <a:p>
          <a:r>
            <a:rPr lang="es-ES" b="1" dirty="0"/>
            <a:t>COVID-19 </a:t>
          </a:r>
          <a:r>
            <a:rPr lang="es-ES" b="1"/>
            <a:t>pathways</a:t>
          </a:r>
          <a:endParaRPr lang="es-ES" b="1" dirty="0"/>
        </a:p>
      </dgm:t>
    </dgm:pt>
    <dgm:pt modelId="{1F408172-3272-534D-8994-96524FF1C349}" type="parTrans" cxnId="{217AAAB7-3A52-304C-AF0E-A18CCBC8311C}">
      <dgm:prSet/>
      <dgm:spPr/>
      <dgm:t>
        <a:bodyPr/>
        <a:lstStyle/>
        <a:p>
          <a:endParaRPr lang="es-ES"/>
        </a:p>
      </dgm:t>
    </dgm:pt>
    <dgm:pt modelId="{3B6B2D05-78C4-1946-823F-172C14DF8E64}" type="sibTrans" cxnId="{217AAAB7-3A52-304C-AF0E-A18CCBC8311C}">
      <dgm:prSet/>
      <dgm:spPr/>
      <dgm:t>
        <a:bodyPr/>
        <a:lstStyle/>
        <a:p>
          <a:endParaRPr lang="es-ES"/>
        </a:p>
      </dgm:t>
    </dgm:pt>
    <dgm:pt modelId="{F6B7D473-C96F-F542-8348-F6503163A4C0}">
      <dgm:prSet phldrT="[Texto]"/>
      <dgm:spPr>
        <a:solidFill>
          <a:schemeClr val="accent6">
            <a:lumMod val="75000"/>
          </a:schemeClr>
        </a:solidFill>
      </dgm:spPr>
      <dgm:t>
        <a:bodyPr/>
        <a:lstStyle/>
        <a:p>
          <a:r>
            <a:rPr lang="en-GB" b="1" noProof="0" dirty="0"/>
            <a:t>Main differences across Europe</a:t>
          </a:r>
        </a:p>
      </dgm:t>
    </dgm:pt>
    <dgm:pt modelId="{125D0C33-750A-F245-9495-A5D7AF109416}" type="parTrans" cxnId="{D2E9EB16-907F-CD4F-995B-E74AA965B852}">
      <dgm:prSet/>
      <dgm:spPr/>
      <dgm:t>
        <a:bodyPr/>
        <a:lstStyle/>
        <a:p>
          <a:endParaRPr lang="es-ES"/>
        </a:p>
      </dgm:t>
    </dgm:pt>
    <dgm:pt modelId="{38388AEA-D9BE-024A-A417-BEACDA180F08}" type="sibTrans" cxnId="{D2E9EB16-907F-CD4F-995B-E74AA965B852}">
      <dgm:prSet/>
      <dgm:spPr/>
      <dgm:t>
        <a:bodyPr/>
        <a:lstStyle/>
        <a:p>
          <a:endParaRPr lang="es-ES"/>
        </a:p>
      </dgm:t>
    </dgm:pt>
    <dgm:pt modelId="{B837191C-484D-0A49-BA5D-9D44BF7E8ECF}">
      <dgm:prSet phldrT="[Texto]"/>
      <dgm:spPr/>
      <dgm:t>
        <a:bodyPr/>
        <a:lstStyle/>
        <a:p>
          <a:r>
            <a:rPr lang="en-GB" b="1" dirty="0">
              <a:effectLst/>
              <a:latin typeface="+mn-lt"/>
              <a:ea typeface="Times New Roman" panose="02020603050405020304" pitchFamily="18" charset="0"/>
              <a:cs typeface="Times New Roman" panose="02020603050405020304" pitchFamily="18" charset="0"/>
            </a:rPr>
            <a:t>Primary care was involved in nearly all steps</a:t>
          </a:r>
          <a:r>
            <a:rPr lang="en-GB" dirty="0">
              <a:effectLst/>
              <a:latin typeface="+mn-lt"/>
              <a:ea typeface="Times New Roman" panose="02020603050405020304" pitchFamily="18" charset="0"/>
              <a:cs typeface="Times New Roman" panose="02020603050405020304" pitchFamily="18" charset="0"/>
            </a:rPr>
            <a:t>:</a:t>
          </a:r>
          <a:endParaRPr lang="es-ES" dirty="0">
            <a:latin typeface="+mn-lt"/>
          </a:endParaRPr>
        </a:p>
      </dgm:t>
    </dgm:pt>
    <dgm:pt modelId="{9C40304E-334A-4841-8B68-937EDC617FD2}" type="parTrans" cxnId="{FA393A26-1811-E344-A779-8CB7B88CFEBB}">
      <dgm:prSet/>
      <dgm:spPr/>
      <dgm:t>
        <a:bodyPr/>
        <a:lstStyle/>
        <a:p>
          <a:endParaRPr lang="es-ES"/>
        </a:p>
      </dgm:t>
    </dgm:pt>
    <dgm:pt modelId="{C8CF11EB-B742-F74D-B7A0-552FCC5A53C9}" type="sibTrans" cxnId="{FA393A26-1811-E344-A779-8CB7B88CFEBB}">
      <dgm:prSet/>
      <dgm:spPr/>
      <dgm:t>
        <a:bodyPr/>
        <a:lstStyle/>
        <a:p>
          <a:endParaRPr lang="es-ES"/>
        </a:p>
      </dgm:t>
    </dgm:pt>
    <dgm:pt modelId="{B114F4AD-5C1F-604E-BBCA-853B66152F3F}">
      <dgm:prSet/>
      <dgm:spPr/>
      <dgm:t>
        <a:bodyPr/>
        <a:lstStyle/>
        <a:p>
          <a:r>
            <a:rPr lang="en-IE" b="1" noProof="0" dirty="0"/>
            <a:t>Setting: </a:t>
          </a:r>
          <a:r>
            <a:rPr lang="en-IE" noProof="0" dirty="0"/>
            <a:t>Primary care</a:t>
          </a:r>
        </a:p>
      </dgm:t>
    </dgm:pt>
    <dgm:pt modelId="{EADEE743-7262-A14F-950D-18F471ABC3AE}" type="parTrans" cxnId="{C970D3C2-6D9F-714F-BE00-3C2D40488EF0}">
      <dgm:prSet/>
      <dgm:spPr/>
      <dgm:t>
        <a:bodyPr/>
        <a:lstStyle/>
        <a:p>
          <a:endParaRPr lang="es-ES"/>
        </a:p>
      </dgm:t>
    </dgm:pt>
    <dgm:pt modelId="{ED05BE2A-41DD-704B-8640-219A0E06F96B}" type="sibTrans" cxnId="{C970D3C2-6D9F-714F-BE00-3C2D40488EF0}">
      <dgm:prSet/>
      <dgm:spPr/>
      <dgm:t>
        <a:bodyPr/>
        <a:lstStyle/>
        <a:p>
          <a:endParaRPr lang="es-ES"/>
        </a:p>
      </dgm:t>
    </dgm:pt>
    <dgm:pt modelId="{9BCC196F-8DFD-8B47-86D2-80B0E0078BD2}">
      <dgm:prSet/>
      <dgm:spPr/>
      <dgm:t>
        <a:bodyPr/>
        <a:lstStyle/>
        <a:p>
          <a:r>
            <a:rPr lang="en-IE" b="1" noProof="0" dirty="0"/>
            <a:t>Participants: </a:t>
          </a:r>
          <a:r>
            <a:rPr lang="en-IE" noProof="0" dirty="0"/>
            <a:t>30 European countries</a:t>
          </a:r>
        </a:p>
      </dgm:t>
    </dgm:pt>
    <dgm:pt modelId="{5CC56A98-8C41-E441-A1AC-90B3DF143F42}" type="parTrans" cxnId="{2D8EF4AD-A446-554C-98A8-A3633333C369}">
      <dgm:prSet/>
      <dgm:spPr/>
      <dgm:t>
        <a:bodyPr/>
        <a:lstStyle/>
        <a:p>
          <a:endParaRPr lang="es-ES"/>
        </a:p>
      </dgm:t>
    </dgm:pt>
    <dgm:pt modelId="{B00EBC55-CEF0-6B46-A4A2-1840945D7AD3}" type="sibTrans" cxnId="{2D8EF4AD-A446-554C-98A8-A3633333C369}">
      <dgm:prSet/>
      <dgm:spPr/>
      <dgm:t>
        <a:bodyPr/>
        <a:lstStyle/>
        <a:p>
          <a:endParaRPr lang="es-ES"/>
        </a:p>
      </dgm:t>
    </dgm:pt>
    <dgm:pt modelId="{26F88231-A9E5-8848-8A80-4CC050F878B8}">
      <dgm:prSet/>
      <dgm:spPr/>
      <dgm:t>
        <a:bodyPr/>
        <a:lstStyle/>
        <a:p>
          <a:r>
            <a:rPr lang="en-IE" b="1" noProof="0" dirty="0"/>
            <a:t>Data collection: </a:t>
          </a:r>
          <a:r>
            <a:rPr lang="en-IE" noProof="0" dirty="0"/>
            <a:t>September 2020</a:t>
          </a:r>
        </a:p>
      </dgm:t>
    </dgm:pt>
    <dgm:pt modelId="{E6CA5C49-FFFF-9644-A653-1A339186D1D4}" type="parTrans" cxnId="{31E2DD0A-75E7-B44D-BFC7-2D4AEB672D54}">
      <dgm:prSet/>
      <dgm:spPr/>
      <dgm:t>
        <a:bodyPr/>
        <a:lstStyle/>
        <a:p>
          <a:endParaRPr lang="es-ES"/>
        </a:p>
      </dgm:t>
    </dgm:pt>
    <dgm:pt modelId="{0C1FBA6E-2523-5441-9D9E-32CF836F0B82}" type="sibTrans" cxnId="{31E2DD0A-75E7-B44D-BFC7-2D4AEB672D54}">
      <dgm:prSet/>
      <dgm:spPr/>
      <dgm:t>
        <a:bodyPr/>
        <a:lstStyle/>
        <a:p>
          <a:endParaRPr lang="es-ES"/>
        </a:p>
      </dgm:t>
    </dgm:pt>
    <dgm:pt modelId="{0F7F9512-B712-9F46-A374-02E76AD323EE}">
      <dgm:prSet phldrT="[Texto]"/>
      <dgm:spPr/>
      <dgm:t>
        <a:bodyPr/>
        <a:lstStyle/>
        <a:p>
          <a:pPr>
            <a:buFont typeface="Wingdings" pitchFamily="2" charset="2"/>
            <a:buChar char="ü"/>
          </a:pPr>
          <a:r>
            <a:rPr lang="en-GB" dirty="0">
              <a:effectLst/>
              <a:latin typeface="+mn-lt"/>
              <a:ea typeface="Times New Roman" panose="02020603050405020304" pitchFamily="18" charset="0"/>
              <a:cs typeface="Times New Roman" panose="02020603050405020304" pitchFamily="18" charset="0"/>
            </a:rPr>
            <a:t> To detect and manage cases</a:t>
          </a:r>
          <a:endParaRPr lang="es-ES" dirty="0">
            <a:latin typeface="+mn-lt"/>
          </a:endParaRPr>
        </a:p>
      </dgm:t>
    </dgm:pt>
    <dgm:pt modelId="{B6BDDA69-D063-3F4B-A3A9-0B02355825F0}" type="parTrans" cxnId="{1802B411-61AD-1640-B84A-19C2F19B2212}">
      <dgm:prSet/>
      <dgm:spPr/>
      <dgm:t>
        <a:bodyPr/>
        <a:lstStyle/>
        <a:p>
          <a:endParaRPr lang="es-ES"/>
        </a:p>
      </dgm:t>
    </dgm:pt>
    <dgm:pt modelId="{2449FCE1-F6A4-6943-B1E3-B6376C774688}" type="sibTrans" cxnId="{1802B411-61AD-1640-B84A-19C2F19B2212}">
      <dgm:prSet/>
      <dgm:spPr/>
      <dgm:t>
        <a:bodyPr/>
        <a:lstStyle/>
        <a:p>
          <a:endParaRPr lang="es-ES"/>
        </a:p>
      </dgm:t>
    </dgm:pt>
    <dgm:pt modelId="{9E34FFB3-9981-504D-9DEA-87759023AAE1}">
      <dgm:prSet phldrT="[Texto]"/>
      <dgm:spPr/>
      <dgm:t>
        <a:bodyPr/>
        <a:lstStyle/>
        <a:p>
          <a:pPr>
            <a:buFont typeface="Wingdings" pitchFamily="2" charset="2"/>
            <a:buChar char="ü"/>
          </a:pPr>
          <a:r>
            <a:rPr lang="en-GB" dirty="0">
              <a:effectLst/>
              <a:latin typeface="+mn-lt"/>
              <a:ea typeface="Times New Roman" panose="02020603050405020304" pitchFamily="18" charset="0"/>
              <a:cs typeface="Times New Roman" panose="02020603050405020304" pitchFamily="18" charset="0"/>
            </a:rPr>
            <a:t> Initial medical care</a:t>
          </a:r>
          <a:endParaRPr lang="es-ES" dirty="0">
            <a:latin typeface="+mn-lt"/>
          </a:endParaRPr>
        </a:p>
      </dgm:t>
    </dgm:pt>
    <dgm:pt modelId="{207FDA94-3CBF-5B48-BFAD-3A186CF6B706}" type="parTrans" cxnId="{249F7472-421E-534B-ABA7-0D6F7A06C658}">
      <dgm:prSet/>
      <dgm:spPr/>
      <dgm:t>
        <a:bodyPr/>
        <a:lstStyle/>
        <a:p>
          <a:endParaRPr lang="es-ES"/>
        </a:p>
      </dgm:t>
    </dgm:pt>
    <dgm:pt modelId="{D0A5C25B-1B34-2644-8F02-E94246604A71}" type="sibTrans" cxnId="{249F7472-421E-534B-ABA7-0D6F7A06C658}">
      <dgm:prSet/>
      <dgm:spPr/>
      <dgm:t>
        <a:bodyPr/>
        <a:lstStyle/>
        <a:p>
          <a:endParaRPr lang="es-ES"/>
        </a:p>
      </dgm:t>
    </dgm:pt>
    <dgm:pt modelId="{EFF6D2BA-E84B-F943-82E1-57169F7AC030}">
      <dgm:prSet phldrT="[Texto]"/>
      <dgm:spPr/>
      <dgm:t>
        <a:bodyPr/>
        <a:lstStyle/>
        <a:p>
          <a:pPr>
            <a:buFont typeface="Wingdings" pitchFamily="2" charset="2"/>
            <a:buChar char="ü"/>
          </a:pPr>
          <a:r>
            <a:rPr lang="en-GB" dirty="0">
              <a:effectLst/>
              <a:latin typeface="+mn-lt"/>
              <a:ea typeface="Times New Roman" panose="02020603050405020304" pitchFamily="18" charset="0"/>
              <a:cs typeface="Times New Roman" panose="02020603050405020304" pitchFamily="18" charset="0"/>
            </a:rPr>
            <a:t> Follow-up</a:t>
          </a:r>
          <a:endParaRPr lang="es-ES" dirty="0">
            <a:latin typeface="+mn-lt"/>
          </a:endParaRPr>
        </a:p>
      </dgm:t>
    </dgm:pt>
    <dgm:pt modelId="{606D370A-FA57-6442-AD9A-C039248F9641}" type="parTrans" cxnId="{57FA35BE-8777-2F46-8EC2-6686DC20F364}">
      <dgm:prSet/>
      <dgm:spPr/>
      <dgm:t>
        <a:bodyPr/>
        <a:lstStyle/>
        <a:p>
          <a:endParaRPr lang="es-ES"/>
        </a:p>
      </dgm:t>
    </dgm:pt>
    <dgm:pt modelId="{E5557C21-E1C4-8C44-B372-E2B93A1A6A55}" type="sibTrans" cxnId="{57FA35BE-8777-2F46-8EC2-6686DC20F364}">
      <dgm:prSet/>
      <dgm:spPr/>
      <dgm:t>
        <a:bodyPr/>
        <a:lstStyle/>
        <a:p>
          <a:endParaRPr lang="es-ES"/>
        </a:p>
      </dgm:t>
    </dgm:pt>
    <dgm:pt modelId="{AB7A1290-781D-3942-B512-A419A1C23FB3}">
      <dgm:prSet phldrT="[Texto]"/>
      <dgm:spPr/>
      <dgm:t>
        <a:bodyPr/>
        <a:lstStyle/>
        <a:p>
          <a:pPr>
            <a:buFont typeface="Wingdings" pitchFamily="2" charset="2"/>
            <a:buChar char="ü"/>
          </a:pPr>
          <a:r>
            <a:rPr lang="en-GB" dirty="0">
              <a:effectLst/>
              <a:latin typeface="+mn-lt"/>
              <a:ea typeface="Times New Roman" panose="02020603050405020304" pitchFamily="18" charset="0"/>
              <a:cs typeface="Times New Roman" panose="02020603050405020304" pitchFamily="18" charset="0"/>
            </a:rPr>
            <a:t>Sick leave allocation</a:t>
          </a:r>
          <a:endParaRPr lang="es-ES" dirty="0">
            <a:latin typeface="+mn-lt"/>
          </a:endParaRPr>
        </a:p>
      </dgm:t>
    </dgm:pt>
    <dgm:pt modelId="{2E04E829-BAD5-7F45-9303-7137F208A9C2}" type="parTrans" cxnId="{78F3E843-DF14-E643-9691-896886F11196}">
      <dgm:prSet/>
      <dgm:spPr/>
      <dgm:t>
        <a:bodyPr/>
        <a:lstStyle/>
        <a:p>
          <a:endParaRPr lang="es-ES"/>
        </a:p>
      </dgm:t>
    </dgm:pt>
    <dgm:pt modelId="{90EBED2F-AB72-2E4E-933C-D233B4C98BD1}" type="sibTrans" cxnId="{78F3E843-DF14-E643-9691-896886F11196}">
      <dgm:prSet/>
      <dgm:spPr/>
      <dgm:t>
        <a:bodyPr/>
        <a:lstStyle/>
        <a:p>
          <a:endParaRPr lang="es-ES"/>
        </a:p>
      </dgm:t>
    </dgm:pt>
    <dgm:pt modelId="{1BBB72C2-E24F-1A45-B997-61539AF9C520}">
      <dgm:prSet/>
      <dgm:spPr/>
      <dgm:t>
        <a:bodyPr/>
        <a:lstStyle/>
        <a:p>
          <a:r>
            <a:rPr lang="en-GB" b="1" dirty="0"/>
            <a:t>It was not fully available in primary care in all countries:</a:t>
          </a:r>
          <a:endParaRPr lang="es-ES" b="1" dirty="0"/>
        </a:p>
      </dgm:t>
    </dgm:pt>
    <dgm:pt modelId="{37F14115-819A-0B41-9A9C-764BC17718C9}" type="parTrans" cxnId="{6BD1D06B-1519-224B-8C50-F88DA5A53368}">
      <dgm:prSet/>
      <dgm:spPr/>
      <dgm:t>
        <a:bodyPr/>
        <a:lstStyle/>
        <a:p>
          <a:endParaRPr lang="es-ES"/>
        </a:p>
      </dgm:t>
    </dgm:pt>
    <dgm:pt modelId="{FCEA1347-59B4-BD49-A4E0-B0FE468184AB}" type="sibTrans" cxnId="{6BD1D06B-1519-224B-8C50-F88DA5A53368}">
      <dgm:prSet/>
      <dgm:spPr/>
      <dgm:t>
        <a:bodyPr/>
        <a:lstStyle/>
        <a:p>
          <a:endParaRPr lang="es-ES"/>
        </a:p>
      </dgm:t>
    </dgm:pt>
    <dgm:pt modelId="{EAD64C20-9270-8542-B474-CCC4E70AB6BA}">
      <dgm:prSet/>
      <dgm:spPr/>
      <dgm:t>
        <a:bodyPr/>
        <a:lstStyle/>
        <a:p>
          <a:pPr>
            <a:buFont typeface="Wingdings" pitchFamily="2" charset="2"/>
            <a:buChar char="ü"/>
          </a:pPr>
          <a:r>
            <a:rPr lang="en-GB" dirty="0"/>
            <a:t> Additional medical examinations (X-Ray, Blood test)</a:t>
          </a:r>
          <a:endParaRPr lang="es-ES" dirty="0"/>
        </a:p>
      </dgm:t>
    </dgm:pt>
    <dgm:pt modelId="{2A99CE89-F6B8-BA4B-A2F2-B56D37148DA1}" type="parTrans" cxnId="{348E9B75-34B0-7543-9A26-52296031BC07}">
      <dgm:prSet/>
      <dgm:spPr/>
      <dgm:t>
        <a:bodyPr/>
        <a:lstStyle/>
        <a:p>
          <a:endParaRPr lang="es-ES"/>
        </a:p>
      </dgm:t>
    </dgm:pt>
    <dgm:pt modelId="{ED45E07C-A882-5447-B0BA-E26FE813BAF3}" type="sibTrans" cxnId="{348E9B75-34B0-7543-9A26-52296031BC07}">
      <dgm:prSet/>
      <dgm:spPr/>
      <dgm:t>
        <a:bodyPr/>
        <a:lstStyle/>
        <a:p>
          <a:endParaRPr lang="es-ES"/>
        </a:p>
      </dgm:t>
    </dgm:pt>
    <dgm:pt modelId="{B419E947-3FF4-B849-95F3-093FB1A2B307}">
      <dgm:prSet/>
      <dgm:spPr/>
      <dgm:t>
        <a:bodyPr/>
        <a:lstStyle/>
        <a:p>
          <a:pPr>
            <a:buFont typeface="Wingdings" pitchFamily="2" charset="2"/>
            <a:buChar char="ü"/>
          </a:pPr>
          <a:r>
            <a:rPr lang="en-GB" dirty="0"/>
            <a:t>Treatments</a:t>
          </a:r>
          <a:endParaRPr lang="es-ES" dirty="0"/>
        </a:p>
      </dgm:t>
    </dgm:pt>
    <dgm:pt modelId="{73B78028-3E8B-ED4A-B248-8BB8ED98D143}" type="parTrans" cxnId="{096C2D98-C06C-6442-ACBA-9483167E445F}">
      <dgm:prSet/>
      <dgm:spPr/>
      <dgm:t>
        <a:bodyPr/>
        <a:lstStyle/>
        <a:p>
          <a:endParaRPr lang="es-ES"/>
        </a:p>
      </dgm:t>
    </dgm:pt>
    <dgm:pt modelId="{D4B4F7EF-E285-0344-994F-DC922F94155F}" type="sibTrans" cxnId="{096C2D98-C06C-6442-ACBA-9483167E445F}">
      <dgm:prSet/>
      <dgm:spPr/>
      <dgm:t>
        <a:bodyPr/>
        <a:lstStyle/>
        <a:p>
          <a:endParaRPr lang="es-ES"/>
        </a:p>
      </dgm:t>
    </dgm:pt>
    <dgm:pt modelId="{CA285E95-CC48-104E-9561-04C8B7F49BEF}">
      <dgm:prSet/>
      <dgm:spPr/>
      <dgm:t>
        <a:bodyPr/>
        <a:lstStyle/>
        <a:p>
          <a:pPr>
            <a:buFont typeface="Wingdings" pitchFamily="2" charset="2"/>
            <a:buChar char="ü"/>
          </a:pPr>
          <a:r>
            <a:rPr lang="en-GB" dirty="0"/>
            <a:t>Physical examination</a:t>
          </a:r>
          <a:endParaRPr lang="es-ES" dirty="0"/>
        </a:p>
      </dgm:t>
    </dgm:pt>
    <dgm:pt modelId="{B6BA77F1-20ED-5444-935B-AE7B133FC1D0}" type="parTrans" cxnId="{21D3F0C4-917B-DD40-A2F1-640A0EF97C7D}">
      <dgm:prSet/>
      <dgm:spPr/>
      <dgm:t>
        <a:bodyPr/>
        <a:lstStyle/>
        <a:p>
          <a:endParaRPr lang="es-ES"/>
        </a:p>
      </dgm:t>
    </dgm:pt>
    <dgm:pt modelId="{A3C3DFFB-1C68-E74F-9474-DC5DDB59BE3C}" type="sibTrans" cxnId="{21D3F0C4-917B-DD40-A2F1-640A0EF97C7D}">
      <dgm:prSet/>
      <dgm:spPr/>
      <dgm:t>
        <a:bodyPr/>
        <a:lstStyle/>
        <a:p>
          <a:endParaRPr lang="es-ES"/>
        </a:p>
      </dgm:t>
    </dgm:pt>
    <dgm:pt modelId="{F25CB7C1-277B-CE46-A27F-EEE2BA046742}">
      <dgm:prSet/>
      <dgm:spPr/>
      <dgm:t>
        <a:bodyPr/>
        <a:lstStyle/>
        <a:p>
          <a:pPr>
            <a:buNone/>
          </a:pPr>
          <a:endParaRPr lang="en-IE" noProof="0" dirty="0"/>
        </a:p>
      </dgm:t>
    </dgm:pt>
    <dgm:pt modelId="{EF43CE41-82AF-D34F-B512-6EC362481210}" type="parTrans" cxnId="{CEC38090-83A7-4B45-B37B-4C16645D505D}">
      <dgm:prSet/>
      <dgm:spPr/>
      <dgm:t>
        <a:bodyPr/>
        <a:lstStyle/>
        <a:p>
          <a:endParaRPr lang="es-ES"/>
        </a:p>
      </dgm:t>
    </dgm:pt>
    <dgm:pt modelId="{3EE41247-803E-B04A-95D0-5319C9A151CE}" type="sibTrans" cxnId="{CEC38090-83A7-4B45-B37B-4C16645D505D}">
      <dgm:prSet/>
      <dgm:spPr/>
      <dgm:t>
        <a:bodyPr/>
        <a:lstStyle/>
        <a:p>
          <a:endParaRPr lang="es-ES"/>
        </a:p>
      </dgm:t>
    </dgm:pt>
    <dgm:pt modelId="{4CAEC9B1-F8F0-A845-8EC9-943C69ABE155}">
      <dgm:prSet/>
      <dgm:spPr/>
      <dgm:t>
        <a:bodyPr/>
        <a:lstStyle/>
        <a:p>
          <a:pPr>
            <a:buNone/>
          </a:pPr>
          <a:endParaRPr lang="en-IE" noProof="0" dirty="0"/>
        </a:p>
      </dgm:t>
    </dgm:pt>
    <dgm:pt modelId="{5376D82F-A1AD-9448-8599-D9C987A8F76A}" type="parTrans" cxnId="{88D01A18-83EA-D241-B61F-D4E5D459A403}">
      <dgm:prSet/>
      <dgm:spPr/>
      <dgm:t>
        <a:bodyPr/>
        <a:lstStyle/>
        <a:p>
          <a:endParaRPr lang="es-ES"/>
        </a:p>
      </dgm:t>
    </dgm:pt>
    <dgm:pt modelId="{56787663-08F1-6B44-8C75-7E7143B3CB27}" type="sibTrans" cxnId="{88D01A18-83EA-D241-B61F-D4E5D459A403}">
      <dgm:prSet/>
      <dgm:spPr/>
      <dgm:t>
        <a:bodyPr/>
        <a:lstStyle/>
        <a:p>
          <a:endParaRPr lang="es-ES"/>
        </a:p>
      </dgm:t>
    </dgm:pt>
    <dgm:pt modelId="{B49247BA-E66E-674C-AD95-4C81254FC7EA}">
      <dgm:prSet phldrT="[Texto]"/>
      <dgm:spPr/>
      <dgm:t>
        <a:bodyPr/>
        <a:lstStyle/>
        <a:p>
          <a:endParaRPr lang="es-ES" dirty="0">
            <a:latin typeface="+mn-lt"/>
          </a:endParaRPr>
        </a:p>
      </dgm:t>
    </dgm:pt>
    <dgm:pt modelId="{DBF79E26-B290-5E4F-9028-B6E8D91B3C1D}" type="parTrans" cxnId="{368833B3-1D37-E741-A9B6-89DB7C52A21E}">
      <dgm:prSet/>
      <dgm:spPr/>
      <dgm:t>
        <a:bodyPr/>
        <a:lstStyle/>
        <a:p>
          <a:endParaRPr lang="es-ES"/>
        </a:p>
      </dgm:t>
    </dgm:pt>
    <dgm:pt modelId="{224A1622-8752-DA47-B097-8F796B10BBBF}" type="sibTrans" cxnId="{368833B3-1D37-E741-A9B6-89DB7C52A21E}">
      <dgm:prSet/>
      <dgm:spPr/>
      <dgm:t>
        <a:bodyPr/>
        <a:lstStyle/>
        <a:p>
          <a:endParaRPr lang="es-ES"/>
        </a:p>
      </dgm:t>
    </dgm:pt>
    <dgm:pt modelId="{BE37CE2E-EBE2-184A-9D86-BB06CFAB7E5E}" type="pres">
      <dgm:prSet presAssocID="{1E4C0D43-5484-164E-9448-9A65D67B2AD1}" presName="diagram" presStyleCnt="0">
        <dgm:presLayoutVars>
          <dgm:dir/>
          <dgm:animLvl val="lvl"/>
          <dgm:resizeHandles val="exact"/>
        </dgm:presLayoutVars>
      </dgm:prSet>
      <dgm:spPr/>
    </dgm:pt>
    <dgm:pt modelId="{FEE4C92B-B802-AC41-BC94-5BF79BCF4710}" type="pres">
      <dgm:prSet presAssocID="{FB58902A-810F-F546-A44E-289395005808}" presName="compNode" presStyleCnt="0"/>
      <dgm:spPr/>
    </dgm:pt>
    <dgm:pt modelId="{17D25F03-30B8-4149-8012-CC45A1D07C3B}" type="pres">
      <dgm:prSet presAssocID="{FB58902A-810F-F546-A44E-289395005808}" presName="childRect" presStyleLbl="bgAcc1" presStyleIdx="0" presStyleCnt="3">
        <dgm:presLayoutVars>
          <dgm:bulletEnabled val="1"/>
        </dgm:presLayoutVars>
      </dgm:prSet>
      <dgm:spPr/>
    </dgm:pt>
    <dgm:pt modelId="{285D0770-FB19-524C-BBE3-7EC26BFCFCE4}" type="pres">
      <dgm:prSet presAssocID="{FB58902A-810F-F546-A44E-289395005808}" presName="parentText" presStyleLbl="node1" presStyleIdx="0" presStyleCnt="0">
        <dgm:presLayoutVars>
          <dgm:chMax val="0"/>
          <dgm:bulletEnabled val="1"/>
        </dgm:presLayoutVars>
      </dgm:prSet>
      <dgm:spPr/>
    </dgm:pt>
    <dgm:pt modelId="{F651B3DE-2A9F-C649-A566-4D2B63ED2E0D}" type="pres">
      <dgm:prSet presAssocID="{FB58902A-810F-F546-A44E-289395005808}" presName="parentRect" presStyleLbl="alignNode1" presStyleIdx="0" presStyleCnt="3" custLinFactNeighborX="-1425"/>
      <dgm:spPr/>
    </dgm:pt>
    <dgm:pt modelId="{16A32D30-6102-4D46-A3C6-1A626D3B8650}" type="pres">
      <dgm:prSet presAssocID="{FB58902A-810F-F546-A44E-289395005808}" presName="adorn" presStyleLbl="fgAccFollowNode1" presStyleIdx="0" presStyleCnt="3"/>
      <dgm:spPr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9000" r="-9000"/>
          </a:stretch>
        </a:blipFill>
      </dgm:spPr>
    </dgm:pt>
    <dgm:pt modelId="{50B9E5F9-0799-6A40-8FC2-E7A772B523C2}" type="pres">
      <dgm:prSet presAssocID="{0B3B1669-BB90-7E41-88F5-684ECF2869E8}" presName="sibTrans" presStyleLbl="sibTrans2D1" presStyleIdx="0" presStyleCnt="0"/>
      <dgm:spPr/>
    </dgm:pt>
    <dgm:pt modelId="{A66336A2-4A40-B442-8969-313D3B19DA10}" type="pres">
      <dgm:prSet presAssocID="{F40605C9-494D-2A45-B265-19A6B81688B0}" presName="compNode" presStyleCnt="0"/>
      <dgm:spPr/>
    </dgm:pt>
    <dgm:pt modelId="{D7EC26A2-0924-064E-8B39-6706C2952120}" type="pres">
      <dgm:prSet presAssocID="{F40605C9-494D-2A45-B265-19A6B81688B0}" presName="childRect" presStyleLbl="bgAcc1" presStyleIdx="1" presStyleCnt="3">
        <dgm:presLayoutVars>
          <dgm:bulletEnabled val="1"/>
        </dgm:presLayoutVars>
      </dgm:prSet>
      <dgm:spPr/>
    </dgm:pt>
    <dgm:pt modelId="{2A9FC214-68A2-5345-BD2C-2DD3008779A9}" type="pres">
      <dgm:prSet presAssocID="{F40605C9-494D-2A45-B265-19A6B81688B0}" presName="parentText" presStyleLbl="node1" presStyleIdx="0" presStyleCnt="0">
        <dgm:presLayoutVars>
          <dgm:chMax val="0"/>
          <dgm:bulletEnabled val="1"/>
        </dgm:presLayoutVars>
      </dgm:prSet>
      <dgm:spPr/>
    </dgm:pt>
    <dgm:pt modelId="{301F55F1-6BE9-4246-811B-8E360EAD9BB4}" type="pres">
      <dgm:prSet presAssocID="{F40605C9-494D-2A45-B265-19A6B81688B0}" presName="parentRect" presStyleLbl="alignNode1" presStyleIdx="1" presStyleCnt="3"/>
      <dgm:spPr/>
    </dgm:pt>
    <dgm:pt modelId="{7C827F9A-5A1E-454C-BBD1-E298C11BCEE1}" type="pres">
      <dgm:prSet presAssocID="{F40605C9-494D-2A45-B265-19A6B81688B0}" presName="adorn" presStyleLbl="fgAccFollowNode1" presStyleIdx="1" presStyleCnt="3"/>
      <dgm:spPr>
        <a:blipFill>
          <a:blip xmlns:r="http://schemas.openxmlformats.org/officeDocument/2006/relationships"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a:blipFill>
      </dgm:spPr>
    </dgm:pt>
    <dgm:pt modelId="{98D099AC-6103-A54E-9394-D6109DA86D26}" type="pres">
      <dgm:prSet presAssocID="{3B6B2D05-78C4-1946-823F-172C14DF8E64}" presName="sibTrans" presStyleLbl="sibTrans2D1" presStyleIdx="0" presStyleCnt="0"/>
      <dgm:spPr/>
    </dgm:pt>
    <dgm:pt modelId="{A567D7B8-4CD9-7546-BFFA-82BB34E70B95}" type="pres">
      <dgm:prSet presAssocID="{F6B7D473-C96F-F542-8348-F6503163A4C0}" presName="compNode" presStyleCnt="0"/>
      <dgm:spPr/>
    </dgm:pt>
    <dgm:pt modelId="{0C786647-8B87-9C49-A4D4-0341F1289474}" type="pres">
      <dgm:prSet presAssocID="{F6B7D473-C96F-F542-8348-F6503163A4C0}" presName="childRect" presStyleLbl="bgAcc1" presStyleIdx="2" presStyleCnt="3">
        <dgm:presLayoutVars>
          <dgm:bulletEnabled val="1"/>
        </dgm:presLayoutVars>
      </dgm:prSet>
      <dgm:spPr/>
    </dgm:pt>
    <dgm:pt modelId="{18991DCE-6923-1B40-9EAF-25A9356ED77D}" type="pres">
      <dgm:prSet presAssocID="{F6B7D473-C96F-F542-8348-F6503163A4C0}" presName="parentText" presStyleLbl="node1" presStyleIdx="0" presStyleCnt="0">
        <dgm:presLayoutVars>
          <dgm:chMax val="0"/>
          <dgm:bulletEnabled val="1"/>
        </dgm:presLayoutVars>
      </dgm:prSet>
      <dgm:spPr/>
    </dgm:pt>
    <dgm:pt modelId="{A1EE7259-D8D3-D94F-B388-5D471CED65B7}" type="pres">
      <dgm:prSet presAssocID="{F6B7D473-C96F-F542-8348-F6503163A4C0}" presName="parentRect" presStyleLbl="alignNode1" presStyleIdx="2" presStyleCnt="3"/>
      <dgm:spPr/>
    </dgm:pt>
    <dgm:pt modelId="{473FD5E5-A6C9-024A-9A85-A45B4506D4A5}" type="pres">
      <dgm:prSet presAssocID="{F6B7D473-C96F-F542-8348-F6503163A4C0}" presName="adorn" presStyleLbl="fgAccFollowNode1" presStyleIdx="2" presStyleCnt="3"/>
      <dgm:spPr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a:blipFill>
      </dgm:spPr>
    </dgm:pt>
  </dgm:ptLst>
  <dgm:cxnLst>
    <dgm:cxn modelId="{E535CC00-5E12-7C4C-9C5C-E18E66B03920}" type="presOf" srcId="{1E4C0D43-5484-164E-9448-9A65D67B2AD1}" destId="{BE37CE2E-EBE2-184A-9D86-BB06CFAB7E5E}" srcOrd="0" destOrd="0" presId="urn:microsoft.com/office/officeart/2005/8/layout/bList2"/>
    <dgm:cxn modelId="{A0F19602-72A0-CD4D-ABDF-3602BCEA81CE}" type="presOf" srcId="{EFF6D2BA-E84B-F943-82E1-57169F7AC030}" destId="{D7EC26A2-0924-064E-8B39-6706C2952120}" srcOrd="0" destOrd="4" presId="urn:microsoft.com/office/officeart/2005/8/layout/bList2"/>
    <dgm:cxn modelId="{E0510103-6BA3-4A46-8379-7213A3978DF6}" type="presOf" srcId="{0B3B1669-BB90-7E41-88F5-684ECF2869E8}" destId="{50B9E5F9-0799-6A40-8FC2-E7A772B523C2}" srcOrd="0" destOrd="0" presId="urn:microsoft.com/office/officeart/2005/8/layout/bList2"/>
    <dgm:cxn modelId="{86321C08-8B8D-F246-880B-4089A297397E}" type="presOf" srcId="{26F88231-A9E5-8848-8A80-4CC050F878B8}" destId="{17D25F03-30B8-4149-8012-CC45A1D07C3B}" srcOrd="0" destOrd="4" presId="urn:microsoft.com/office/officeart/2005/8/layout/bList2"/>
    <dgm:cxn modelId="{31E2DD0A-75E7-B44D-BFC7-2D4AEB672D54}" srcId="{FB58902A-810F-F546-A44E-289395005808}" destId="{26F88231-A9E5-8848-8A80-4CC050F878B8}" srcOrd="4" destOrd="0" parTransId="{E6CA5C49-FFFF-9644-A653-1A339186D1D4}" sibTransId="{0C1FBA6E-2523-5441-9D9E-32CF836F0B82}"/>
    <dgm:cxn modelId="{C5298B0B-B219-8D45-8E4D-2E2096A32030}" type="presOf" srcId="{9BCC196F-8DFD-8B47-86D2-80B0E0078BD2}" destId="{17D25F03-30B8-4149-8012-CC45A1D07C3B}" srcOrd="0" destOrd="2" presId="urn:microsoft.com/office/officeart/2005/8/layout/bList2"/>
    <dgm:cxn modelId="{1802B411-61AD-1640-B84A-19C2F19B2212}" srcId="{F40605C9-494D-2A45-B265-19A6B81688B0}" destId="{0F7F9512-B712-9F46-A374-02E76AD323EE}" srcOrd="2" destOrd="0" parTransId="{B6BDDA69-D063-3F4B-A3A9-0B02355825F0}" sibTransId="{2449FCE1-F6A4-6943-B1E3-B6376C774688}"/>
    <dgm:cxn modelId="{D2E9EB16-907F-CD4F-995B-E74AA965B852}" srcId="{1E4C0D43-5484-164E-9448-9A65D67B2AD1}" destId="{F6B7D473-C96F-F542-8348-F6503163A4C0}" srcOrd="2" destOrd="0" parTransId="{125D0C33-750A-F245-9495-A5D7AF109416}" sibTransId="{38388AEA-D9BE-024A-A417-BEACDA180F08}"/>
    <dgm:cxn modelId="{88D01A18-83EA-D241-B61F-D4E5D459A403}" srcId="{FB58902A-810F-F546-A44E-289395005808}" destId="{4CAEC9B1-F8F0-A845-8EC9-943C69ABE155}" srcOrd="3" destOrd="0" parTransId="{5376D82F-A1AD-9448-8599-D9C987A8F76A}" sibTransId="{56787663-08F1-6B44-8C75-7E7143B3CB27}"/>
    <dgm:cxn modelId="{96585023-54CC-E549-A095-F253BEFBD225}" type="presOf" srcId="{EAD64C20-9270-8542-B474-CCC4E70AB6BA}" destId="{0C786647-8B87-9C49-A4D4-0341F1289474}" srcOrd="0" destOrd="2" presId="urn:microsoft.com/office/officeart/2005/8/layout/bList2"/>
    <dgm:cxn modelId="{FA393A26-1811-E344-A779-8CB7B88CFEBB}" srcId="{F40605C9-494D-2A45-B265-19A6B81688B0}" destId="{B837191C-484D-0A49-BA5D-9D44BF7E8ECF}" srcOrd="0" destOrd="0" parTransId="{9C40304E-334A-4841-8B68-937EDC617FD2}" sibTransId="{C8CF11EB-B742-F74D-B7A0-552FCC5A53C9}"/>
    <dgm:cxn modelId="{4ADDCB29-E7A1-144E-BC1A-F211D7BC65E3}" type="presOf" srcId="{F6B7D473-C96F-F542-8348-F6503163A4C0}" destId="{A1EE7259-D8D3-D94F-B388-5D471CED65B7}" srcOrd="1" destOrd="0" presId="urn:microsoft.com/office/officeart/2005/8/layout/bList2"/>
    <dgm:cxn modelId="{1E8FCC2D-9E1B-FF4E-8E05-6A1964A4422C}" type="presOf" srcId="{B419E947-3FF4-B849-95F3-093FB1A2B307}" destId="{0C786647-8B87-9C49-A4D4-0341F1289474}" srcOrd="0" destOrd="3" presId="urn:microsoft.com/office/officeart/2005/8/layout/bList2"/>
    <dgm:cxn modelId="{7A9B4D3D-BC15-B44D-AEB5-39D92F25EA4C}" type="presOf" srcId="{F25CB7C1-277B-CE46-A27F-EEE2BA046742}" destId="{17D25F03-30B8-4149-8012-CC45A1D07C3B}" srcOrd="0" destOrd="1" presId="urn:microsoft.com/office/officeart/2005/8/layout/bList2"/>
    <dgm:cxn modelId="{78F3E843-DF14-E643-9691-896886F11196}" srcId="{F40605C9-494D-2A45-B265-19A6B81688B0}" destId="{AB7A1290-781D-3942-B512-A419A1C23FB3}" srcOrd="5" destOrd="0" parTransId="{2E04E829-BAD5-7F45-9303-7137F208A9C2}" sibTransId="{90EBED2F-AB72-2E4E-933C-D233B4C98BD1}"/>
    <dgm:cxn modelId="{6750984A-E2D2-D54B-8DF0-A41B5193DC18}" type="presOf" srcId="{4CAEC9B1-F8F0-A845-8EC9-943C69ABE155}" destId="{17D25F03-30B8-4149-8012-CC45A1D07C3B}" srcOrd="0" destOrd="3" presId="urn:microsoft.com/office/officeart/2005/8/layout/bList2"/>
    <dgm:cxn modelId="{1D47564F-5C76-6C4C-9022-2D4AF5F650F9}" type="presOf" srcId="{B114F4AD-5C1F-604E-BBCA-853B66152F3F}" destId="{17D25F03-30B8-4149-8012-CC45A1D07C3B}" srcOrd="0" destOrd="0" presId="urn:microsoft.com/office/officeart/2005/8/layout/bList2"/>
    <dgm:cxn modelId="{44A6BD51-E39C-8D43-83FB-CD7CC45B8A67}" type="presOf" srcId="{AB7A1290-781D-3942-B512-A419A1C23FB3}" destId="{D7EC26A2-0924-064E-8B39-6706C2952120}" srcOrd="0" destOrd="5" presId="urn:microsoft.com/office/officeart/2005/8/layout/bList2"/>
    <dgm:cxn modelId="{684B0662-E2FC-184A-9641-A2103A6524B2}" srcId="{1E4C0D43-5484-164E-9448-9A65D67B2AD1}" destId="{FB58902A-810F-F546-A44E-289395005808}" srcOrd="0" destOrd="0" parTransId="{736097F9-C76F-5F4F-88B6-B19C430C34F7}" sibTransId="{0B3B1669-BB90-7E41-88F5-684ECF2869E8}"/>
    <dgm:cxn modelId="{45DC1A62-5BDE-944F-B815-A7937E001D99}" type="presOf" srcId="{1BBB72C2-E24F-1A45-B997-61539AF9C520}" destId="{0C786647-8B87-9C49-A4D4-0341F1289474}" srcOrd="0" destOrd="0" presId="urn:microsoft.com/office/officeart/2005/8/layout/bList2"/>
    <dgm:cxn modelId="{6BD1D06B-1519-224B-8C50-F88DA5A53368}" srcId="{F6B7D473-C96F-F542-8348-F6503163A4C0}" destId="{1BBB72C2-E24F-1A45-B997-61539AF9C520}" srcOrd="0" destOrd="0" parTransId="{37F14115-819A-0B41-9A9C-764BC17718C9}" sibTransId="{FCEA1347-59B4-BD49-A4E0-B0FE468184AB}"/>
    <dgm:cxn modelId="{249F7472-421E-534B-ABA7-0D6F7A06C658}" srcId="{F40605C9-494D-2A45-B265-19A6B81688B0}" destId="{9E34FFB3-9981-504D-9DEA-87759023AAE1}" srcOrd="3" destOrd="0" parTransId="{207FDA94-3CBF-5B48-BFAD-3A186CF6B706}" sibTransId="{D0A5C25B-1B34-2644-8F02-E94246604A71}"/>
    <dgm:cxn modelId="{348E9B75-34B0-7543-9A26-52296031BC07}" srcId="{F6B7D473-C96F-F542-8348-F6503163A4C0}" destId="{EAD64C20-9270-8542-B474-CCC4E70AB6BA}" srcOrd="2" destOrd="0" parTransId="{2A99CE89-F6B8-BA4B-A2F2-B56D37148DA1}" sibTransId="{ED45E07C-A882-5447-B0BA-E26FE813BAF3}"/>
    <dgm:cxn modelId="{CEC38090-83A7-4B45-B37B-4C16645D505D}" srcId="{FB58902A-810F-F546-A44E-289395005808}" destId="{F25CB7C1-277B-CE46-A27F-EEE2BA046742}" srcOrd="1" destOrd="0" parTransId="{EF43CE41-82AF-D34F-B512-6EC362481210}" sibTransId="{3EE41247-803E-B04A-95D0-5319C9A151CE}"/>
    <dgm:cxn modelId="{EEE13A93-5C8D-0843-B61F-497B08A70AA3}" type="presOf" srcId="{B49247BA-E66E-674C-AD95-4C81254FC7EA}" destId="{D7EC26A2-0924-064E-8B39-6706C2952120}" srcOrd="0" destOrd="1" presId="urn:microsoft.com/office/officeart/2005/8/layout/bList2"/>
    <dgm:cxn modelId="{096C2D98-C06C-6442-ACBA-9483167E445F}" srcId="{F6B7D473-C96F-F542-8348-F6503163A4C0}" destId="{B419E947-3FF4-B849-95F3-093FB1A2B307}" srcOrd="3" destOrd="0" parTransId="{73B78028-3E8B-ED4A-B248-8BB8ED98D143}" sibTransId="{D4B4F7EF-E285-0344-994F-DC922F94155F}"/>
    <dgm:cxn modelId="{B7C0BB98-AC7E-6647-9E1C-2BC1D659A309}" type="presOf" srcId="{3B6B2D05-78C4-1946-823F-172C14DF8E64}" destId="{98D099AC-6103-A54E-9394-D6109DA86D26}" srcOrd="0" destOrd="0" presId="urn:microsoft.com/office/officeart/2005/8/layout/bList2"/>
    <dgm:cxn modelId="{EBC778A2-99A8-8642-9562-2DCCBC5F6079}" type="presOf" srcId="{F40605C9-494D-2A45-B265-19A6B81688B0}" destId="{2A9FC214-68A2-5345-BD2C-2DD3008779A9}" srcOrd="0" destOrd="0" presId="urn:microsoft.com/office/officeart/2005/8/layout/bList2"/>
    <dgm:cxn modelId="{AD6380A2-6EFC-5448-AD8F-B8FF7AEF177B}" type="presOf" srcId="{0F7F9512-B712-9F46-A374-02E76AD323EE}" destId="{D7EC26A2-0924-064E-8B39-6706C2952120}" srcOrd="0" destOrd="2" presId="urn:microsoft.com/office/officeart/2005/8/layout/bList2"/>
    <dgm:cxn modelId="{2D8EF4AD-A446-554C-98A8-A3633333C369}" srcId="{FB58902A-810F-F546-A44E-289395005808}" destId="{9BCC196F-8DFD-8B47-86D2-80B0E0078BD2}" srcOrd="2" destOrd="0" parTransId="{5CC56A98-8C41-E441-A1AC-90B3DF143F42}" sibTransId="{B00EBC55-CEF0-6B46-A4A2-1840945D7AD3}"/>
    <dgm:cxn modelId="{90C6AEAE-C6C6-FB43-A3BF-20C734787451}" type="presOf" srcId="{F40605C9-494D-2A45-B265-19A6B81688B0}" destId="{301F55F1-6BE9-4246-811B-8E360EAD9BB4}" srcOrd="1" destOrd="0" presId="urn:microsoft.com/office/officeart/2005/8/layout/bList2"/>
    <dgm:cxn modelId="{368833B3-1D37-E741-A9B6-89DB7C52A21E}" srcId="{F40605C9-494D-2A45-B265-19A6B81688B0}" destId="{B49247BA-E66E-674C-AD95-4C81254FC7EA}" srcOrd="1" destOrd="0" parTransId="{DBF79E26-B290-5E4F-9028-B6E8D91B3C1D}" sibTransId="{224A1622-8752-DA47-B097-8F796B10BBBF}"/>
    <dgm:cxn modelId="{217AAAB7-3A52-304C-AF0E-A18CCBC8311C}" srcId="{1E4C0D43-5484-164E-9448-9A65D67B2AD1}" destId="{F40605C9-494D-2A45-B265-19A6B81688B0}" srcOrd="1" destOrd="0" parTransId="{1F408172-3272-534D-8994-96524FF1C349}" sibTransId="{3B6B2D05-78C4-1946-823F-172C14DF8E64}"/>
    <dgm:cxn modelId="{57FA35BE-8777-2F46-8EC2-6686DC20F364}" srcId="{F40605C9-494D-2A45-B265-19A6B81688B0}" destId="{EFF6D2BA-E84B-F943-82E1-57169F7AC030}" srcOrd="4" destOrd="0" parTransId="{606D370A-FA57-6442-AD9A-C039248F9641}" sibTransId="{E5557C21-E1C4-8C44-B372-E2B93A1A6A55}"/>
    <dgm:cxn modelId="{27BD36BF-5F33-624A-BD29-63F307E77447}" type="presOf" srcId="{CA285E95-CC48-104E-9561-04C8B7F49BEF}" destId="{0C786647-8B87-9C49-A4D4-0341F1289474}" srcOrd="0" destOrd="1" presId="urn:microsoft.com/office/officeart/2005/8/layout/bList2"/>
    <dgm:cxn modelId="{C970D3C2-6D9F-714F-BE00-3C2D40488EF0}" srcId="{FB58902A-810F-F546-A44E-289395005808}" destId="{B114F4AD-5C1F-604E-BBCA-853B66152F3F}" srcOrd="0" destOrd="0" parTransId="{EADEE743-7262-A14F-950D-18F471ABC3AE}" sibTransId="{ED05BE2A-41DD-704B-8640-219A0E06F96B}"/>
    <dgm:cxn modelId="{21D3F0C4-917B-DD40-A2F1-640A0EF97C7D}" srcId="{F6B7D473-C96F-F542-8348-F6503163A4C0}" destId="{CA285E95-CC48-104E-9561-04C8B7F49BEF}" srcOrd="1" destOrd="0" parTransId="{B6BA77F1-20ED-5444-935B-AE7B133FC1D0}" sibTransId="{A3C3DFFB-1C68-E74F-9474-DC5DDB59BE3C}"/>
    <dgm:cxn modelId="{0BB919D7-71B0-9045-9B48-A33839BCB985}" type="presOf" srcId="{9E34FFB3-9981-504D-9DEA-87759023AAE1}" destId="{D7EC26A2-0924-064E-8B39-6706C2952120}" srcOrd="0" destOrd="3" presId="urn:microsoft.com/office/officeart/2005/8/layout/bList2"/>
    <dgm:cxn modelId="{D6064BE4-4374-D646-94EA-13B11CD91037}" type="presOf" srcId="{F6B7D473-C96F-F542-8348-F6503163A4C0}" destId="{18991DCE-6923-1B40-9EAF-25A9356ED77D}" srcOrd="0" destOrd="0" presId="urn:microsoft.com/office/officeart/2005/8/layout/bList2"/>
    <dgm:cxn modelId="{C79BDDED-916F-1C46-9C9C-4876DE901B94}" type="presOf" srcId="{FB58902A-810F-F546-A44E-289395005808}" destId="{285D0770-FB19-524C-BBE3-7EC26BFCFCE4}" srcOrd="0" destOrd="0" presId="urn:microsoft.com/office/officeart/2005/8/layout/bList2"/>
    <dgm:cxn modelId="{10DCB0EF-3390-8E42-99E5-A7C6E4A3F07B}" type="presOf" srcId="{FB58902A-810F-F546-A44E-289395005808}" destId="{F651B3DE-2A9F-C649-A566-4D2B63ED2E0D}" srcOrd="1" destOrd="0" presId="urn:microsoft.com/office/officeart/2005/8/layout/bList2"/>
    <dgm:cxn modelId="{ED32C8FB-AA29-C540-8A40-C2025DB769D6}" type="presOf" srcId="{B837191C-484D-0A49-BA5D-9D44BF7E8ECF}" destId="{D7EC26A2-0924-064E-8B39-6706C2952120}" srcOrd="0" destOrd="0" presId="urn:microsoft.com/office/officeart/2005/8/layout/bList2"/>
    <dgm:cxn modelId="{55425CD3-8D2F-6746-8412-9B9D034B161B}" type="presParOf" srcId="{BE37CE2E-EBE2-184A-9D86-BB06CFAB7E5E}" destId="{FEE4C92B-B802-AC41-BC94-5BF79BCF4710}" srcOrd="0" destOrd="0" presId="urn:microsoft.com/office/officeart/2005/8/layout/bList2"/>
    <dgm:cxn modelId="{A7BDF118-4EEE-6D40-A629-F1348DAFDE58}" type="presParOf" srcId="{FEE4C92B-B802-AC41-BC94-5BF79BCF4710}" destId="{17D25F03-30B8-4149-8012-CC45A1D07C3B}" srcOrd="0" destOrd="0" presId="urn:microsoft.com/office/officeart/2005/8/layout/bList2"/>
    <dgm:cxn modelId="{4105D7AE-70D0-9247-9B77-852171AFF4BF}" type="presParOf" srcId="{FEE4C92B-B802-AC41-BC94-5BF79BCF4710}" destId="{285D0770-FB19-524C-BBE3-7EC26BFCFCE4}" srcOrd="1" destOrd="0" presId="urn:microsoft.com/office/officeart/2005/8/layout/bList2"/>
    <dgm:cxn modelId="{ED04F165-92D2-EB4F-8CF3-F206810D9D85}" type="presParOf" srcId="{FEE4C92B-B802-AC41-BC94-5BF79BCF4710}" destId="{F651B3DE-2A9F-C649-A566-4D2B63ED2E0D}" srcOrd="2" destOrd="0" presId="urn:microsoft.com/office/officeart/2005/8/layout/bList2"/>
    <dgm:cxn modelId="{85A967B3-55C7-7947-A48B-887B68E92DA3}" type="presParOf" srcId="{FEE4C92B-B802-AC41-BC94-5BF79BCF4710}" destId="{16A32D30-6102-4D46-A3C6-1A626D3B8650}" srcOrd="3" destOrd="0" presId="urn:microsoft.com/office/officeart/2005/8/layout/bList2"/>
    <dgm:cxn modelId="{63568BAA-96EB-544E-9B1C-4C099A3AAB22}" type="presParOf" srcId="{BE37CE2E-EBE2-184A-9D86-BB06CFAB7E5E}" destId="{50B9E5F9-0799-6A40-8FC2-E7A772B523C2}" srcOrd="1" destOrd="0" presId="urn:microsoft.com/office/officeart/2005/8/layout/bList2"/>
    <dgm:cxn modelId="{CF16FCB9-4310-A343-A14C-6AC31F7DBC87}" type="presParOf" srcId="{BE37CE2E-EBE2-184A-9D86-BB06CFAB7E5E}" destId="{A66336A2-4A40-B442-8969-313D3B19DA10}" srcOrd="2" destOrd="0" presId="urn:microsoft.com/office/officeart/2005/8/layout/bList2"/>
    <dgm:cxn modelId="{1BD8C978-736A-484E-ADE1-C907F48A1AEB}" type="presParOf" srcId="{A66336A2-4A40-B442-8969-313D3B19DA10}" destId="{D7EC26A2-0924-064E-8B39-6706C2952120}" srcOrd="0" destOrd="0" presId="urn:microsoft.com/office/officeart/2005/8/layout/bList2"/>
    <dgm:cxn modelId="{DF1C58DA-A65A-0E41-AD9C-BED251118537}" type="presParOf" srcId="{A66336A2-4A40-B442-8969-313D3B19DA10}" destId="{2A9FC214-68A2-5345-BD2C-2DD3008779A9}" srcOrd="1" destOrd="0" presId="urn:microsoft.com/office/officeart/2005/8/layout/bList2"/>
    <dgm:cxn modelId="{E025FFB8-DD89-F841-96E1-E8EE577672C7}" type="presParOf" srcId="{A66336A2-4A40-B442-8969-313D3B19DA10}" destId="{301F55F1-6BE9-4246-811B-8E360EAD9BB4}" srcOrd="2" destOrd="0" presId="urn:microsoft.com/office/officeart/2005/8/layout/bList2"/>
    <dgm:cxn modelId="{E5F2085C-7BBB-F14C-9332-D561C79D3853}" type="presParOf" srcId="{A66336A2-4A40-B442-8969-313D3B19DA10}" destId="{7C827F9A-5A1E-454C-BBD1-E298C11BCEE1}" srcOrd="3" destOrd="0" presId="urn:microsoft.com/office/officeart/2005/8/layout/bList2"/>
    <dgm:cxn modelId="{86A65A13-C04D-1243-9C6A-C4E611FD38C2}" type="presParOf" srcId="{BE37CE2E-EBE2-184A-9D86-BB06CFAB7E5E}" destId="{98D099AC-6103-A54E-9394-D6109DA86D26}" srcOrd="3" destOrd="0" presId="urn:microsoft.com/office/officeart/2005/8/layout/bList2"/>
    <dgm:cxn modelId="{3851782B-0D73-F847-AE14-191FA0C16BEB}" type="presParOf" srcId="{BE37CE2E-EBE2-184A-9D86-BB06CFAB7E5E}" destId="{A567D7B8-4CD9-7546-BFFA-82BB34E70B95}" srcOrd="4" destOrd="0" presId="urn:microsoft.com/office/officeart/2005/8/layout/bList2"/>
    <dgm:cxn modelId="{95C4611A-E7DC-D543-A290-EBE5278D9C1E}" type="presParOf" srcId="{A567D7B8-4CD9-7546-BFFA-82BB34E70B95}" destId="{0C786647-8B87-9C49-A4D4-0341F1289474}" srcOrd="0" destOrd="0" presId="urn:microsoft.com/office/officeart/2005/8/layout/bList2"/>
    <dgm:cxn modelId="{402E95EE-9360-F843-935D-5B46AD7A2B04}" type="presParOf" srcId="{A567D7B8-4CD9-7546-BFFA-82BB34E70B95}" destId="{18991DCE-6923-1B40-9EAF-25A9356ED77D}" srcOrd="1" destOrd="0" presId="urn:microsoft.com/office/officeart/2005/8/layout/bList2"/>
    <dgm:cxn modelId="{91AE5D5F-23F9-4C40-95DB-8398CE103E50}" type="presParOf" srcId="{A567D7B8-4CD9-7546-BFFA-82BB34E70B95}" destId="{A1EE7259-D8D3-D94F-B388-5D471CED65B7}" srcOrd="2" destOrd="0" presId="urn:microsoft.com/office/officeart/2005/8/layout/bList2"/>
    <dgm:cxn modelId="{F9FBBB7D-4645-8C4B-BD6D-3206C254D502}" type="presParOf" srcId="{A567D7B8-4CD9-7546-BFFA-82BB34E70B95}" destId="{473FD5E5-A6C9-024A-9A85-A45B4506D4A5}" srcOrd="3" destOrd="0" presId="urn:microsoft.com/office/officeart/2005/8/layout/bList2"/>
  </dgm:cxnLst>
  <dgm:bg/>
  <dgm:whole/>
  <dgm:extLst>
    <a:ext uri="http://schemas.microsoft.com/office/drawing/2008/diagram">
      <dsp:dataModelExt xmlns:dsp="http://schemas.microsoft.com/office/drawing/2008/diagram" relId="rId8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17D25F03-30B8-4149-8012-CC45A1D07C3B}">
      <dsp:nvSpPr>
        <dsp:cNvPr id="0" name=""/>
        <dsp:cNvSpPr/>
      </dsp:nvSpPr>
      <dsp:spPr>
        <a:xfrm>
          <a:off x="7205" y="1871981"/>
          <a:ext cx="3112286" cy="2323256"/>
        </a:xfrm>
        <a:prstGeom prst="round2SameRect">
          <a:avLst>
            <a:gd name="adj1" fmla="val 8000"/>
            <a:gd name="adj2" fmla="val 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6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2860" tIns="68580" rIns="22860" bIns="22860" numCol="1" spcCol="1270" anchor="t" anchorCtr="0">
          <a:noAutofit/>
        </a:bodyPr>
        <a:lstStyle/>
        <a:p>
          <a:pPr marL="171450" lvl="1" indent="-171450" algn="l" defTabSz="8001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IE" sz="1800" b="1" kern="1200" noProof="0" dirty="0"/>
            <a:t>Setting: </a:t>
          </a:r>
          <a:r>
            <a:rPr lang="en-IE" sz="1800" kern="1200" noProof="0" dirty="0"/>
            <a:t>Primary care</a:t>
          </a:r>
        </a:p>
        <a:p>
          <a:pPr marL="171450" lvl="1" indent="-171450" algn="l" defTabSz="800100">
            <a:lnSpc>
              <a:spcPct val="90000"/>
            </a:lnSpc>
            <a:spcBef>
              <a:spcPct val="0"/>
            </a:spcBef>
            <a:spcAft>
              <a:spcPct val="15000"/>
            </a:spcAft>
            <a:buNone/>
          </a:pPr>
          <a:endParaRPr lang="en-IE" sz="1800" kern="1200" noProof="0" dirty="0"/>
        </a:p>
        <a:p>
          <a:pPr marL="171450" lvl="1" indent="-171450" algn="l" defTabSz="8001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IE" sz="1800" b="1" kern="1200" noProof="0" dirty="0"/>
            <a:t>Participants: </a:t>
          </a:r>
          <a:r>
            <a:rPr lang="en-IE" sz="1800" kern="1200" noProof="0" dirty="0"/>
            <a:t>30 European countries</a:t>
          </a:r>
        </a:p>
        <a:p>
          <a:pPr marL="171450" lvl="1" indent="-171450" algn="l" defTabSz="800100">
            <a:lnSpc>
              <a:spcPct val="90000"/>
            </a:lnSpc>
            <a:spcBef>
              <a:spcPct val="0"/>
            </a:spcBef>
            <a:spcAft>
              <a:spcPct val="15000"/>
            </a:spcAft>
            <a:buNone/>
          </a:pPr>
          <a:endParaRPr lang="en-IE" sz="1800" kern="1200" noProof="0" dirty="0"/>
        </a:p>
        <a:p>
          <a:pPr marL="171450" lvl="1" indent="-171450" algn="l" defTabSz="8001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IE" sz="1800" b="1" kern="1200" noProof="0" dirty="0"/>
            <a:t>Data collection: </a:t>
          </a:r>
          <a:r>
            <a:rPr lang="en-IE" sz="1800" kern="1200" noProof="0" dirty="0"/>
            <a:t>September 2020</a:t>
          </a:r>
        </a:p>
      </dsp:txBody>
      <dsp:txXfrm>
        <a:off x="61642" y="1926418"/>
        <a:ext cx="3003412" cy="2268819"/>
      </dsp:txXfrm>
    </dsp:sp>
    <dsp:sp modelId="{F651B3DE-2A9F-C649-A566-4D2B63ED2E0D}">
      <dsp:nvSpPr>
        <dsp:cNvPr id="0" name=""/>
        <dsp:cNvSpPr/>
      </dsp:nvSpPr>
      <dsp:spPr>
        <a:xfrm>
          <a:off x="0" y="4195237"/>
          <a:ext cx="3112286" cy="999000"/>
        </a:xfrm>
        <a:prstGeom prst="rect">
          <a:avLst/>
        </a:prstGeom>
        <a:solidFill>
          <a:schemeClr val="accent6">
            <a:lumMod val="75000"/>
          </a:schemeClr>
        </a:solidFill>
        <a:ln w="12700" cap="flat" cmpd="sng" algn="ctr">
          <a:solidFill>
            <a:schemeClr val="accent6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87630" tIns="0" rIns="29210" bIns="0" numCol="1" spcCol="1270" anchor="ctr" anchorCtr="0">
          <a:noAutofit/>
        </a:bodyPr>
        <a:lstStyle/>
        <a:p>
          <a:pPr marL="0" lvl="0" indent="0" algn="l" defTabSz="10223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s-ES" sz="2300" b="1" kern="1200" dirty="0"/>
            <a:t>Descriptive study</a:t>
          </a:r>
        </a:p>
      </dsp:txBody>
      <dsp:txXfrm>
        <a:off x="0" y="4195237"/>
        <a:ext cx="2191751" cy="999000"/>
      </dsp:txXfrm>
    </dsp:sp>
    <dsp:sp modelId="{16A32D30-6102-4D46-A3C6-1A626D3B8650}">
      <dsp:nvSpPr>
        <dsp:cNvPr id="0" name=""/>
        <dsp:cNvSpPr/>
      </dsp:nvSpPr>
      <dsp:spPr>
        <a:xfrm>
          <a:off x="2286998" y="4353919"/>
          <a:ext cx="1089300" cy="1089300"/>
        </a:xfrm>
        <a:prstGeom prst="ellipse">
          <a:avLst/>
        </a:prstGeom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9000" r="-9000"/>
          </a:stretch>
        </a:blipFill>
        <a:ln w="12700" cap="flat" cmpd="sng" algn="ctr">
          <a:solidFill>
            <a:schemeClr val="accent6">
              <a:alpha val="90000"/>
              <a:tint val="4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D7EC26A2-0924-064E-8B39-6706C2952120}">
      <dsp:nvSpPr>
        <dsp:cNvPr id="0" name=""/>
        <dsp:cNvSpPr/>
      </dsp:nvSpPr>
      <dsp:spPr>
        <a:xfrm>
          <a:off x="3646166" y="1871981"/>
          <a:ext cx="3112286" cy="2323256"/>
        </a:xfrm>
        <a:prstGeom prst="round2SameRect">
          <a:avLst>
            <a:gd name="adj1" fmla="val 8000"/>
            <a:gd name="adj2" fmla="val 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6">
              <a:shade val="80000"/>
              <a:hueOff val="160640"/>
              <a:satOff val="-6455"/>
              <a:lumOff val="13814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2860" tIns="68580" rIns="22860" bIns="22860" numCol="1" spcCol="1270" anchor="t" anchorCtr="0">
          <a:noAutofit/>
        </a:bodyPr>
        <a:lstStyle/>
        <a:p>
          <a:pPr marL="171450" lvl="1" indent="-171450" algn="l" defTabSz="8001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GB" sz="1800" b="1" kern="1200" dirty="0">
              <a:effectLst/>
              <a:latin typeface="+mn-lt"/>
              <a:ea typeface="Times New Roman" panose="02020603050405020304" pitchFamily="18" charset="0"/>
              <a:cs typeface="Times New Roman" panose="02020603050405020304" pitchFamily="18" charset="0"/>
            </a:rPr>
            <a:t>Primary care was involved in nearly all steps</a:t>
          </a:r>
          <a:r>
            <a:rPr lang="en-GB" sz="1800" kern="1200" dirty="0">
              <a:effectLst/>
              <a:latin typeface="+mn-lt"/>
              <a:ea typeface="Times New Roman" panose="02020603050405020304" pitchFamily="18" charset="0"/>
              <a:cs typeface="Times New Roman" panose="02020603050405020304" pitchFamily="18" charset="0"/>
            </a:rPr>
            <a:t>:</a:t>
          </a:r>
          <a:endParaRPr lang="es-ES" sz="1800" kern="1200" dirty="0">
            <a:latin typeface="+mn-lt"/>
          </a:endParaRPr>
        </a:p>
        <a:p>
          <a:pPr marL="171450" lvl="1" indent="-171450" algn="l" defTabSz="8001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endParaRPr lang="es-ES" sz="1800" kern="1200" dirty="0">
            <a:latin typeface="+mn-lt"/>
          </a:endParaRPr>
        </a:p>
        <a:p>
          <a:pPr marL="171450" lvl="1" indent="-171450" algn="l" defTabSz="800100">
            <a:lnSpc>
              <a:spcPct val="90000"/>
            </a:lnSpc>
            <a:spcBef>
              <a:spcPct val="0"/>
            </a:spcBef>
            <a:spcAft>
              <a:spcPct val="15000"/>
            </a:spcAft>
            <a:buFont typeface="Wingdings" pitchFamily="2" charset="2"/>
            <a:buChar char="ü"/>
          </a:pPr>
          <a:r>
            <a:rPr lang="en-GB" sz="1800" kern="1200" dirty="0">
              <a:effectLst/>
              <a:latin typeface="+mn-lt"/>
              <a:ea typeface="Times New Roman" panose="02020603050405020304" pitchFamily="18" charset="0"/>
              <a:cs typeface="Times New Roman" panose="02020603050405020304" pitchFamily="18" charset="0"/>
            </a:rPr>
            <a:t> To detect and manage cases</a:t>
          </a:r>
          <a:endParaRPr lang="es-ES" sz="1800" kern="1200" dirty="0">
            <a:latin typeface="+mn-lt"/>
          </a:endParaRPr>
        </a:p>
        <a:p>
          <a:pPr marL="171450" lvl="1" indent="-171450" algn="l" defTabSz="800100">
            <a:lnSpc>
              <a:spcPct val="90000"/>
            </a:lnSpc>
            <a:spcBef>
              <a:spcPct val="0"/>
            </a:spcBef>
            <a:spcAft>
              <a:spcPct val="15000"/>
            </a:spcAft>
            <a:buFont typeface="Wingdings" pitchFamily="2" charset="2"/>
            <a:buChar char="ü"/>
          </a:pPr>
          <a:r>
            <a:rPr lang="en-GB" sz="1800" kern="1200" dirty="0">
              <a:effectLst/>
              <a:latin typeface="+mn-lt"/>
              <a:ea typeface="Times New Roman" panose="02020603050405020304" pitchFamily="18" charset="0"/>
              <a:cs typeface="Times New Roman" panose="02020603050405020304" pitchFamily="18" charset="0"/>
            </a:rPr>
            <a:t> Initial medical care</a:t>
          </a:r>
          <a:endParaRPr lang="es-ES" sz="1800" kern="1200" dirty="0">
            <a:latin typeface="+mn-lt"/>
          </a:endParaRPr>
        </a:p>
        <a:p>
          <a:pPr marL="171450" lvl="1" indent="-171450" algn="l" defTabSz="800100">
            <a:lnSpc>
              <a:spcPct val="90000"/>
            </a:lnSpc>
            <a:spcBef>
              <a:spcPct val="0"/>
            </a:spcBef>
            <a:spcAft>
              <a:spcPct val="15000"/>
            </a:spcAft>
            <a:buFont typeface="Wingdings" pitchFamily="2" charset="2"/>
            <a:buChar char="ü"/>
          </a:pPr>
          <a:r>
            <a:rPr lang="en-GB" sz="1800" kern="1200" dirty="0">
              <a:effectLst/>
              <a:latin typeface="+mn-lt"/>
              <a:ea typeface="Times New Roman" panose="02020603050405020304" pitchFamily="18" charset="0"/>
              <a:cs typeface="Times New Roman" panose="02020603050405020304" pitchFamily="18" charset="0"/>
            </a:rPr>
            <a:t> Follow-up</a:t>
          </a:r>
          <a:endParaRPr lang="es-ES" sz="1800" kern="1200" dirty="0">
            <a:latin typeface="+mn-lt"/>
          </a:endParaRPr>
        </a:p>
        <a:p>
          <a:pPr marL="171450" lvl="1" indent="-171450" algn="l" defTabSz="800100">
            <a:lnSpc>
              <a:spcPct val="90000"/>
            </a:lnSpc>
            <a:spcBef>
              <a:spcPct val="0"/>
            </a:spcBef>
            <a:spcAft>
              <a:spcPct val="15000"/>
            </a:spcAft>
            <a:buFont typeface="Wingdings" pitchFamily="2" charset="2"/>
            <a:buChar char="ü"/>
          </a:pPr>
          <a:r>
            <a:rPr lang="en-GB" sz="1800" kern="1200" dirty="0">
              <a:effectLst/>
              <a:latin typeface="+mn-lt"/>
              <a:ea typeface="Times New Roman" panose="02020603050405020304" pitchFamily="18" charset="0"/>
              <a:cs typeface="Times New Roman" panose="02020603050405020304" pitchFamily="18" charset="0"/>
            </a:rPr>
            <a:t>Sick leave allocation</a:t>
          </a:r>
          <a:endParaRPr lang="es-ES" sz="1800" kern="1200" dirty="0">
            <a:latin typeface="+mn-lt"/>
          </a:endParaRPr>
        </a:p>
      </dsp:txBody>
      <dsp:txXfrm>
        <a:off x="3700603" y="1926418"/>
        <a:ext cx="3003412" cy="2268819"/>
      </dsp:txXfrm>
    </dsp:sp>
    <dsp:sp modelId="{301F55F1-6BE9-4246-811B-8E360EAD9BB4}">
      <dsp:nvSpPr>
        <dsp:cNvPr id="0" name=""/>
        <dsp:cNvSpPr/>
      </dsp:nvSpPr>
      <dsp:spPr>
        <a:xfrm>
          <a:off x="3646166" y="4195237"/>
          <a:ext cx="3112286" cy="999000"/>
        </a:xfrm>
        <a:prstGeom prst="rect">
          <a:avLst/>
        </a:prstGeom>
        <a:solidFill>
          <a:schemeClr val="accent6">
            <a:lumMod val="75000"/>
          </a:schemeClr>
        </a:solidFill>
        <a:ln w="12700" cap="flat" cmpd="sng" algn="ctr">
          <a:solidFill>
            <a:schemeClr val="accent6">
              <a:shade val="80000"/>
              <a:hueOff val="160640"/>
              <a:satOff val="-6455"/>
              <a:lumOff val="13814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87630" tIns="0" rIns="29210" bIns="0" numCol="1" spcCol="1270" anchor="ctr" anchorCtr="0">
          <a:noAutofit/>
        </a:bodyPr>
        <a:lstStyle/>
        <a:p>
          <a:pPr marL="0" lvl="0" indent="0" algn="l" defTabSz="10223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s-ES" sz="2300" b="1" kern="1200" dirty="0"/>
            <a:t>COVID-19 </a:t>
          </a:r>
          <a:r>
            <a:rPr lang="es-ES" sz="2300" b="1" kern="1200"/>
            <a:t>pathways</a:t>
          </a:r>
          <a:endParaRPr lang="es-ES" sz="2300" b="1" kern="1200" dirty="0"/>
        </a:p>
      </dsp:txBody>
      <dsp:txXfrm>
        <a:off x="3646166" y="4195237"/>
        <a:ext cx="2191751" cy="999000"/>
      </dsp:txXfrm>
    </dsp:sp>
    <dsp:sp modelId="{7C827F9A-5A1E-454C-BBD1-E298C11BCEE1}">
      <dsp:nvSpPr>
        <dsp:cNvPr id="0" name=""/>
        <dsp:cNvSpPr/>
      </dsp:nvSpPr>
      <dsp:spPr>
        <a:xfrm>
          <a:off x="5925958" y="4353919"/>
          <a:ext cx="1089300" cy="1089300"/>
        </a:xfrm>
        <a:prstGeom prst="ellipse">
          <a:avLst/>
        </a:prstGeom>
        <a:blipFill>
          <a:blip xmlns:r="http://schemas.openxmlformats.org/officeDocument/2006/relationships"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a:blipFill>
        <a:ln w="12700" cap="flat" cmpd="sng" algn="ctr">
          <a:solidFill>
            <a:schemeClr val="accent6">
              <a:alpha val="90000"/>
              <a:tint val="4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0C786647-8B87-9C49-A4D4-0341F1289474}">
      <dsp:nvSpPr>
        <dsp:cNvPr id="0" name=""/>
        <dsp:cNvSpPr/>
      </dsp:nvSpPr>
      <dsp:spPr>
        <a:xfrm>
          <a:off x="7285126" y="1871981"/>
          <a:ext cx="3112286" cy="2323256"/>
        </a:xfrm>
        <a:prstGeom prst="round2SameRect">
          <a:avLst>
            <a:gd name="adj1" fmla="val 8000"/>
            <a:gd name="adj2" fmla="val 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6">
              <a:shade val="80000"/>
              <a:hueOff val="321280"/>
              <a:satOff val="-12909"/>
              <a:lumOff val="27628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2860" tIns="68580" rIns="22860" bIns="22860" numCol="1" spcCol="1270" anchor="t" anchorCtr="0">
          <a:noAutofit/>
        </a:bodyPr>
        <a:lstStyle/>
        <a:p>
          <a:pPr marL="171450" lvl="1" indent="-171450" algn="l" defTabSz="8001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GB" sz="1800" b="1" kern="1200" dirty="0"/>
            <a:t>It was not fully available in primary care in all countries:</a:t>
          </a:r>
          <a:endParaRPr lang="es-ES" sz="1800" b="1" kern="1200" dirty="0"/>
        </a:p>
        <a:p>
          <a:pPr marL="171450" lvl="1" indent="-171450" algn="l" defTabSz="800100">
            <a:lnSpc>
              <a:spcPct val="90000"/>
            </a:lnSpc>
            <a:spcBef>
              <a:spcPct val="0"/>
            </a:spcBef>
            <a:spcAft>
              <a:spcPct val="15000"/>
            </a:spcAft>
            <a:buFont typeface="Wingdings" pitchFamily="2" charset="2"/>
            <a:buChar char="ü"/>
          </a:pPr>
          <a:r>
            <a:rPr lang="en-GB" sz="1800" kern="1200" dirty="0"/>
            <a:t>Physical examination</a:t>
          </a:r>
          <a:endParaRPr lang="es-ES" sz="1800" kern="1200" dirty="0"/>
        </a:p>
        <a:p>
          <a:pPr marL="171450" lvl="1" indent="-171450" algn="l" defTabSz="800100">
            <a:lnSpc>
              <a:spcPct val="90000"/>
            </a:lnSpc>
            <a:spcBef>
              <a:spcPct val="0"/>
            </a:spcBef>
            <a:spcAft>
              <a:spcPct val="15000"/>
            </a:spcAft>
            <a:buFont typeface="Wingdings" pitchFamily="2" charset="2"/>
            <a:buChar char="ü"/>
          </a:pPr>
          <a:r>
            <a:rPr lang="en-GB" sz="1800" kern="1200" dirty="0"/>
            <a:t> Additional medical examinations (X-Ray, Blood test)</a:t>
          </a:r>
          <a:endParaRPr lang="es-ES" sz="1800" kern="1200" dirty="0"/>
        </a:p>
        <a:p>
          <a:pPr marL="171450" lvl="1" indent="-171450" algn="l" defTabSz="800100">
            <a:lnSpc>
              <a:spcPct val="90000"/>
            </a:lnSpc>
            <a:spcBef>
              <a:spcPct val="0"/>
            </a:spcBef>
            <a:spcAft>
              <a:spcPct val="15000"/>
            </a:spcAft>
            <a:buFont typeface="Wingdings" pitchFamily="2" charset="2"/>
            <a:buChar char="ü"/>
          </a:pPr>
          <a:r>
            <a:rPr lang="en-GB" sz="1800" kern="1200" dirty="0"/>
            <a:t>Treatments</a:t>
          </a:r>
          <a:endParaRPr lang="es-ES" sz="1800" kern="1200" dirty="0"/>
        </a:p>
      </dsp:txBody>
      <dsp:txXfrm>
        <a:off x="7339563" y="1926418"/>
        <a:ext cx="3003412" cy="2268819"/>
      </dsp:txXfrm>
    </dsp:sp>
    <dsp:sp modelId="{A1EE7259-D8D3-D94F-B388-5D471CED65B7}">
      <dsp:nvSpPr>
        <dsp:cNvPr id="0" name=""/>
        <dsp:cNvSpPr/>
      </dsp:nvSpPr>
      <dsp:spPr>
        <a:xfrm>
          <a:off x="7285126" y="4195237"/>
          <a:ext cx="3112286" cy="999000"/>
        </a:xfrm>
        <a:prstGeom prst="rect">
          <a:avLst/>
        </a:prstGeom>
        <a:solidFill>
          <a:schemeClr val="accent6">
            <a:lumMod val="75000"/>
          </a:schemeClr>
        </a:solidFill>
        <a:ln w="12700" cap="flat" cmpd="sng" algn="ctr">
          <a:solidFill>
            <a:schemeClr val="accent6">
              <a:shade val="80000"/>
              <a:hueOff val="321280"/>
              <a:satOff val="-12909"/>
              <a:lumOff val="27628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87630" tIns="0" rIns="29210" bIns="0" numCol="1" spcCol="1270" anchor="ctr" anchorCtr="0">
          <a:noAutofit/>
        </a:bodyPr>
        <a:lstStyle/>
        <a:p>
          <a:pPr marL="0" lvl="0" indent="0" algn="l" defTabSz="10223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2300" b="1" kern="1200" noProof="0" dirty="0"/>
            <a:t>Main differences across Europe</a:t>
          </a:r>
        </a:p>
      </dsp:txBody>
      <dsp:txXfrm>
        <a:off x="7285126" y="4195237"/>
        <a:ext cx="2191751" cy="999000"/>
      </dsp:txXfrm>
    </dsp:sp>
    <dsp:sp modelId="{473FD5E5-A6C9-024A-9A85-A45B4506D4A5}">
      <dsp:nvSpPr>
        <dsp:cNvPr id="0" name=""/>
        <dsp:cNvSpPr/>
      </dsp:nvSpPr>
      <dsp:spPr>
        <a:xfrm>
          <a:off x="9564918" y="4353919"/>
          <a:ext cx="1089300" cy="1089300"/>
        </a:xfrm>
        <a:prstGeom prst="ellipse">
          <a:avLst/>
        </a:prstGeom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a:blipFill>
        <a:ln w="12700" cap="flat" cmpd="sng" algn="ctr">
          <a:solidFill>
            <a:schemeClr val="accent6">
              <a:alpha val="90000"/>
              <a:tint val="4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bList2">
  <dgm:title val=""/>
  <dgm:desc val=""/>
  <dgm:catLst>
    <dgm:cat type="list" pri="7000"/>
    <dgm:cat type="convert" pri="16000"/>
    <dgm:cat type="picture" pri="28000"/>
    <dgm:cat type="pictureconvert" pri="28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11"/>
        <dgm:pt modelId="2"/>
        <dgm:pt modelId="21"/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diagram">
    <dgm:varLst>
      <dgm:dir/>
      <dgm:animLvl val="lvl"/>
      <dgm:resizeHandles val="exact"/>
    </dgm:varLst>
    <dgm:choose name="Name0">
      <dgm:if name="Name1" axis="self" func="var" arg="dir" op="equ" val="norm">
        <dgm:alg type="snake">
          <dgm:param type="grDir" val="tL"/>
          <dgm:param type="flowDir" val="row"/>
          <dgm:param type="contDir" val="sameDir"/>
          <dgm:param type="off" val="ctr"/>
        </dgm:alg>
      </dgm:if>
      <dgm:else name="Name2">
        <dgm:alg type="snake">
          <dgm:param type="grDir" val="tR"/>
          <dgm:param type="flowDir" val="row"/>
          <dgm:param type="contDir" val="sameDir"/>
          <dgm:param type="off" val="ctr"/>
        </dgm:alg>
      </dgm:else>
    </dgm:choose>
    <dgm:shape xmlns:r="http://schemas.openxmlformats.org/officeDocument/2006/relationships" r:blip="">
      <dgm:adjLst/>
    </dgm:shape>
    <dgm:presOf/>
    <dgm:constrLst>
      <dgm:constr type="w" for="ch" forName="compNode" refType="w"/>
      <dgm:constr type="w" for="ch" ptType="sibTrans" refType="w" refFor="ch" refForName="compNode" op="equ" fact="0.08"/>
      <dgm:constr type="sp" refType="w" refFor="ch" refForName="compNode" op="equ" fact="0.16"/>
      <dgm:constr type="primFontSz" for="des" forName="parentText" op="equ" val="65"/>
      <dgm:constr type="primFontSz" for="des" forName="childRect" op="equ" val="65"/>
    </dgm:constrLst>
    <dgm:ruleLst/>
    <dgm:forEach name="nodesForEach" axis="ch" ptType="node">
      <dgm:layoutNode name="compNode">
        <dgm:alg type="composite">
          <dgm:param type="ar" val="0.943"/>
        </dgm:alg>
        <dgm:shape xmlns:r="http://schemas.openxmlformats.org/officeDocument/2006/relationships" r:blip="">
          <dgm:adjLst/>
        </dgm:shape>
        <dgm:presOf/>
        <dgm:choose name="Name3">
          <dgm:if name="Name4" axis="self" func="var" arg="dir" op="equ" val="norm">
            <dgm:constrLst>
              <dgm:constr type="w" val="1"/>
              <dgm:constr type="h" refType="w" fact="1.06"/>
              <dgm:constr type="h" for="ch" forName="childRect" refType="h" fact="0.65"/>
              <dgm:constr type="w" for="ch" forName="childRect" refType="w" fact="0.923"/>
              <dgm:constr type="l" for="ch" forName="childRect"/>
              <dgm:constr type="t" for="ch" forName="childRect"/>
              <dgm:constr type="w" for="ch" forName="parentText" refType="w" fact="0.65"/>
              <dgm:constr type="h" for="ch" forName="parentText" refType="h" refFor="ch" refForName="childRect" fact="0.43"/>
              <dgm:constr type="l" for="ch" forName="parentText"/>
              <dgm:constr type="t" for="ch" forName="parentText" refType="h" refFor="ch" refForName="childRect"/>
              <dgm:constr type="w" for="ch" forName="parentRect" refType="w" fact="0.923"/>
              <dgm:constr type="h" for="ch" forName="parentRect" refType="h" refFor="ch" refForName="parentText"/>
              <dgm:constr type="l" for="ch" forName="parentRect"/>
              <dgm:constr type="t" for="ch" forName="parentRect" refType="t" refFor="ch" refForName="parentText"/>
              <dgm:constr type="w" for="ch" forName="adorn" refType="w" refFor="ch" refForName="parentRect" fact="0.35"/>
              <dgm:constr type="h" for="ch" forName="adorn" refType="w" refFor="ch" refForName="parentRect" fact="0.35"/>
              <dgm:constr type="b" for="ch" forName="adorn" refType="h"/>
              <dgm:constr type="r" for="ch" forName="adorn" refType="w"/>
            </dgm:constrLst>
          </dgm:if>
          <dgm:else name="Name5">
            <dgm:constrLst>
              <dgm:constr type="w" val="1"/>
              <dgm:constr type="h" refType="w" fact="1.06"/>
              <dgm:constr type="h" for="ch" forName="childRect" refType="h" fact="0.65"/>
              <dgm:constr type="w" for="ch" forName="childRect" refType="w" fact="0.923"/>
              <dgm:constr type="r" for="ch" forName="childRect" refType="w"/>
              <dgm:constr type="t" for="ch" forName="childRect"/>
              <dgm:constr type="w" for="ch" forName="parentText" refType="w" fact="0.65"/>
              <dgm:constr type="h" for="ch" forName="parentText" refType="h" refFor="ch" refForName="childRect" fact="0.43"/>
              <dgm:constr type="r" for="ch" forName="parentText" refType="w"/>
              <dgm:constr type="t" for="ch" forName="parentText" refType="h" refFor="ch" refForName="childRect"/>
              <dgm:constr type="w" for="ch" forName="parentRect" refType="w" fact="0.923"/>
              <dgm:constr type="h" for="ch" forName="parentRect" refType="h" refFor="ch" refForName="parentText"/>
              <dgm:constr type="r" for="ch" forName="parentRect" refType="w"/>
              <dgm:constr type="t" for="ch" forName="parentRect" refType="t" refFor="ch" refForName="parentText"/>
              <dgm:constr type="w" for="ch" forName="adorn" refType="w" refFor="ch" refForName="parentRect" fact="0.35"/>
              <dgm:constr type="h" for="ch" forName="adorn" refType="w" refFor="ch" refForName="parentRect" fact="0.35"/>
              <dgm:constr type="b" for="ch" forName="adorn" refType="h"/>
              <dgm:constr type="l" for="ch" forName="adorn"/>
            </dgm:constrLst>
          </dgm:else>
        </dgm:choose>
        <dgm:ruleLst/>
        <dgm:layoutNode name="childRect" styleLbl="bgAcc1">
          <dgm:varLst>
            <dgm:bulletEnabled val="1"/>
          </dgm:varLst>
          <dgm:alg type="tx">
            <dgm:param type="stBulletLvl" val="1"/>
          </dgm:alg>
          <dgm:shape xmlns:r="http://schemas.openxmlformats.org/officeDocument/2006/relationships" type="round2SameRect" r:blip="">
            <dgm:adjLst>
              <dgm:adj idx="1" val="0.08"/>
            </dgm:adjLst>
          </dgm:shape>
          <dgm:presOf axis="des" ptType="node"/>
          <dgm:constrLst>
            <dgm:constr type="secFontSz" refType="primFontSz"/>
            <dgm:constr type="tMarg" refType="primFontSz" fact="0.3"/>
            <dgm:constr type="bMarg" refType="primFontSz" fact="0.1"/>
            <dgm:constr type="lMarg" refType="primFontSz" fact="0.1"/>
            <dgm:constr type="rMarg" refType="primFontSz" fact="0.1"/>
          </dgm:constrLst>
          <dgm:ruleLst>
            <dgm:rule type="primFontSz" val="5" fact="NaN" max="NaN"/>
          </dgm:ruleLst>
        </dgm:layoutNode>
        <dgm:layoutNode name="parentText">
          <dgm:varLst>
            <dgm:chMax val="0"/>
            <dgm:bulletEnabled val="1"/>
          </dgm:varLst>
          <dgm:choose name="Name6">
            <dgm:if name="Name7" func="var" arg="dir" op="equ" val="norm">
              <dgm:alg type="tx">
                <dgm:param type="parTxLTRAlign" val="l"/>
                <dgm:param type="parTxRTLAlign" val="l"/>
              </dgm:alg>
            </dgm:if>
            <dgm:else name="Name8">
              <dgm:alg type="tx">
                <dgm:param type="parTxLTRAlign" val="r"/>
                <dgm:param type="parTxRTLAlign" val="r"/>
              </dgm:alg>
            </dgm:else>
          </dgm:choose>
          <dgm:shape xmlns:r="http://schemas.openxmlformats.org/officeDocument/2006/relationships" type="rect" r:blip="" zOrderOff="1" hideGeom="1">
            <dgm:adjLst/>
          </dgm:shape>
          <dgm:presOf axis="self" ptType="node"/>
          <dgm:constrLst>
            <dgm:constr type="tMarg"/>
            <dgm:constr type="bMarg"/>
            <dgm:constr type="lMarg" refType="primFontSz" fact="0.3"/>
            <dgm:constr type="rMarg" refType="primFontSz" fact="0.1"/>
          </dgm:constrLst>
          <dgm:ruleLst>
            <dgm:rule type="primFontSz" val="5" fact="NaN" max="NaN"/>
          </dgm:ruleLst>
        </dgm:layoutNode>
        <dgm:layoutNode name="parentRect" styleLbl="alignNode1">
          <dgm:alg type="sp"/>
          <dgm:shape xmlns:r="http://schemas.openxmlformats.org/officeDocument/2006/relationships" type="rect" r:blip="">
            <dgm:adjLst/>
          </dgm:shape>
          <dgm:presOf axis="self" ptType="node"/>
          <dgm:constrLst/>
          <dgm:ruleLst/>
        </dgm:layoutNode>
        <dgm:layoutNode name="adorn" styleLbl="fgAccFollowNode1">
          <dgm:alg type="sp"/>
          <dgm:shape xmlns:r="http://schemas.openxmlformats.org/officeDocument/2006/relationships" type="ellipse" r:blip="" blipPhldr="1">
            <dgm:adjLst/>
          </dgm:shape>
          <dgm:presOf/>
          <dgm:constrLst/>
          <dgm:ruleLst/>
        </dgm:layoutNode>
      </dgm:layoutNode>
      <dgm:forEach name="sibTransForEach" axis="followSib" ptType="sibTrans" cnt="1">
        <dgm:layoutNode name="sibTrans">
          <dgm:alg type="sp"/>
          <dgm:shape xmlns:r="http://schemas.openxmlformats.org/officeDocument/2006/relationships" type="rect" r:blip="" hideGeom="1">
            <dgm:adjLst/>
          </dgm:shape>
          <dgm:presOf axis="self"/>
          <dgm:constrLst>
            <dgm:constr type="w" val="1"/>
            <dgm:constr type="h" refType="w"/>
          </dgm:constrLst>
          <dgm:ruleLst/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2">
  <dgm:title val=""/>
  <dgm:desc val=""/>
  <dgm:catLst>
    <dgm:cat type="simple" pri="102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DE1B3E-3ABA-7343-B06C-F67890542210}" type="datetimeFigureOut">
              <a:rPr lang="en-GB" smtClean="0"/>
              <a:t>03/02/2023</a:t>
            </a:fld>
            <a:endParaRPr lang="en-GB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7B5907-EACE-3542-A63C-1B9D12F05FB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872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A7B5907-EACE-3542-A63C-1B9D12F05FB7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45303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31BA06A-2AC3-3C3C-C2DC-34B13225A7C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D233FEA0-2691-F382-E289-696A3044685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GB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BA4825F-7BFF-2E14-EF60-14451EC9AC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B7383-51F2-3347-B6BB-4BB7908CA829}" type="datetimeFigureOut">
              <a:rPr lang="en-GB" smtClean="0"/>
              <a:t>03/02/2023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FBACCA6-A97D-2726-4651-702081D867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8BD2B25-1C00-BAEC-133F-15303A595F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AEF9E-2B3A-D34B-9694-092F35924B1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9979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80C1DAE-1C06-50F5-09F1-445F49DD81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2C4F4FAF-F4E8-3FB4-7748-6447D6DEF8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A069281-169B-BDE5-B711-4A1E0C221E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B7383-51F2-3347-B6BB-4BB7908CA829}" type="datetimeFigureOut">
              <a:rPr lang="en-GB" smtClean="0"/>
              <a:t>03/02/2023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7EFD117-CA7C-5C27-9060-DB635264B7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70A3733-B977-C7C6-C12B-52F0FF03E1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AEF9E-2B3A-D34B-9694-092F35924B1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34774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35B13B84-5CB2-874C-F007-A6E4CB5224C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F5738A40-56ED-A092-7F58-7F0B62A226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BB32552-2AD0-962E-DFDE-B6C7F6961A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B7383-51F2-3347-B6BB-4BB7908CA829}" type="datetimeFigureOut">
              <a:rPr lang="en-GB" smtClean="0"/>
              <a:t>03/02/2023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DA15A6B-04AC-CB16-D43D-CAEF90A835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47E41BE-3E8F-E968-949C-CD79686A63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AEF9E-2B3A-D34B-9694-092F35924B1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04256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ADCDD38-9A1B-E79F-2FCE-825A7C4EA8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AFBAAE77-9B76-B3EA-84AB-10030981AED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F7D4BC8-8113-3FD3-6999-0C4842F789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B7383-51F2-3347-B6BB-4BB7908CA829}" type="datetimeFigureOut">
              <a:rPr lang="en-GB" smtClean="0"/>
              <a:t>03/02/2023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2998F2C-F4A9-AEE5-1C7D-C0ACE906E1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527D581-9EEE-6C6E-365D-DF764B4CAB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AEF9E-2B3A-D34B-9694-092F35924B1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32692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DDA98D9-2A77-3353-8CC8-7FE8640CAD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5A3F2C60-E8DC-B306-ED07-4BAE34E79B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3704111-6D94-38B7-0787-91B93D20DE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B7383-51F2-3347-B6BB-4BB7908CA829}" type="datetimeFigureOut">
              <a:rPr lang="en-GB" smtClean="0"/>
              <a:t>03/02/2023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83E0813-65AC-3080-F9F9-F96EAF2D32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C296BAF-ECAB-D0E2-1733-A61BD83343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AEF9E-2B3A-D34B-9694-092F35924B1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67246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CFFF2B6-8E9B-A0B0-101C-B605E7A2AF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BE6EDCAE-00D5-C41D-FDD3-97B2D2D1CDF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CD0AF8E4-44D3-F432-2E10-E20A472A09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276FF394-B77B-3F23-7BFF-99DDCE6817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B7383-51F2-3347-B6BB-4BB7908CA829}" type="datetimeFigureOut">
              <a:rPr lang="en-GB" smtClean="0"/>
              <a:t>03/02/2023</a:t>
            </a:fld>
            <a:endParaRPr lang="en-GB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5A730616-3067-23DE-784F-8F3960B580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3289C847-111D-C481-8E56-3414B121EF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AEF9E-2B3A-D34B-9694-092F35924B1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26216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8A3E344-E3D4-40E6-084A-8BC18AF33E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14CA98BC-F85A-8C11-E970-E12D3E53F0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DF714712-CFE4-3EBC-D3D3-1481009961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7C5ECFED-369B-8D95-8932-13493B4BABF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80D10512-736B-93EA-9B22-D13C2EF117E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2FCBFD29-D2CD-B566-C389-4CEA9F7EF4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B7383-51F2-3347-B6BB-4BB7908CA829}" type="datetimeFigureOut">
              <a:rPr lang="en-GB" smtClean="0"/>
              <a:t>03/02/2023</a:t>
            </a:fld>
            <a:endParaRPr lang="en-GB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DFC9C618-CFC1-8E9E-4189-9A67D75CA7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58F5A7E9-4806-CEE0-D732-9D4752DEF2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AEF9E-2B3A-D34B-9694-092F35924B1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59208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1BA1396-788D-37C3-A55C-09043B7D88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785C16A7-6D69-8352-A8E4-4FC1D3B327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B7383-51F2-3347-B6BB-4BB7908CA829}" type="datetimeFigureOut">
              <a:rPr lang="en-GB" smtClean="0"/>
              <a:t>03/02/2023</a:t>
            </a:fld>
            <a:endParaRPr lang="en-GB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A67BBC4D-E849-A1A6-6735-8F5B58D8A1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E01CEB9B-E014-4E41-E796-44CFF9DABD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AEF9E-2B3A-D34B-9694-092F35924B1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90152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087D3BC6-C2DB-9577-3E21-73DAF41363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B7383-51F2-3347-B6BB-4BB7908CA829}" type="datetimeFigureOut">
              <a:rPr lang="en-GB" smtClean="0"/>
              <a:t>03/02/2023</a:t>
            </a:fld>
            <a:endParaRPr lang="en-GB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EE048021-6A2A-23AC-8E12-D2FE68E5A3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559C59B4-95C4-7408-154B-F67C699483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AEF9E-2B3A-D34B-9694-092F35924B1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57896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3E9AA7A-532A-7AAC-76B8-DC12BC28DB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3A835FC3-6119-3B54-1779-5C606528CB0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2DA0CF49-D560-F02B-F05C-F9BC6934FB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CB8CFA45-B276-AFE4-1D17-64D5F8DD82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B7383-51F2-3347-B6BB-4BB7908CA829}" type="datetimeFigureOut">
              <a:rPr lang="en-GB" smtClean="0"/>
              <a:t>03/02/2023</a:t>
            </a:fld>
            <a:endParaRPr lang="en-GB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F189CD3E-7C72-078B-504C-5B73E93D2E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AEB6A3A-77B9-5184-99A5-11209DA094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AEF9E-2B3A-D34B-9694-092F35924B1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6716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45DCD47-71E2-5FEF-ECC4-45BF84AA46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95F65E4E-8706-4983-27A4-B28130087DB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045E18FA-3838-5C08-6936-22806CCA15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2A834CF0-A15A-227F-7674-CA1D12157C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B7383-51F2-3347-B6BB-4BB7908CA829}" type="datetimeFigureOut">
              <a:rPr lang="en-GB" smtClean="0"/>
              <a:t>03/02/2023</a:t>
            </a:fld>
            <a:endParaRPr lang="en-GB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ECA105A1-8E3C-BA8A-F277-1E45B567B6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DD43E520-44C7-0676-41E4-B9E4D1B4FC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AEF9E-2B3A-D34B-9694-092F35924B1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72420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D7D9F0E2-D1D1-DDBB-C7F2-F310AE0EC7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7605A9A2-1664-EE66-364B-26F98A23EF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D9CF93F-2EDC-E565-20BE-7B832EB8AE6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5B7383-51F2-3347-B6BB-4BB7908CA829}" type="datetimeFigureOut">
              <a:rPr lang="en-GB" smtClean="0"/>
              <a:t>03/02/2023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0E5C23A-987C-36B1-E90F-CE463FA2B2A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BC23CEF-CEF6-CF59-B335-E14B7B6D4BA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8AEF9E-2B3A-D34B-9694-092F35924B1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98262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diagramDrawing" Target="../diagrams/drawing1.xml"/><Relationship Id="rId3" Type="http://schemas.openxmlformats.org/officeDocument/2006/relationships/image" Target="../media/image1.png"/><Relationship Id="rId7" Type="http://schemas.openxmlformats.org/officeDocument/2006/relationships/diagramColors" Target="../diagrams/colors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diagramQuickStyle" Target="../diagrams/quickStyle1.xml"/><Relationship Id="rId5" Type="http://schemas.openxmlformats.org/officeDocument/2006/relationships/diagramLayout" Target="../diagrams/layout1.xml"/><Relationship Id="rId4" Type="http://schemas.openxmlformats.org/officeDocument/2006/relationships/diagramData" Target="../diagrams/data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>
            <a:extLst>
              <a:ext uri="{FF2B5EF4-FFF2-40B4-BE49-F238E27FC236}">
                <a16:creationId xmlns:a16="http://schemas.microsoft.com/office/drawing/2014/main" id="{057C7E08-DB57-3BAC-2188-BFEF2DA79DB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1374" y="293668"/>
            <a:ext cx="1746026" cy="884500"/>
          </a:xfrm>
          <a:prstGeom prst="rect">
            <a:avLst/>
          </a:prstGeom>
        </p:spPr>
      </p:pic>
      <p:sp>
        <p:nvSpPr>
          <p:cNvPr id="4" name="CuadroTexto 3">
            <a:extLst>
              <a:ext uri="{FF2B5EF4-FFF2-40B4-BE49-F238E27FC236}">
                <a16:creationId xmlns:a16="http://schemas.microsoft.com/office/drawing/2014/main" id="{0A368AA7-82A6-3D0F-FA23-6D55EB500A7F}"/>
              </a:ext>
            </a:extLst>
          </p:cNvPr>
          <p:cNvSpPr txBox="1"/>
          <p:nvPr/>
        </p:nvSpPr>
        <p:spPr>
          <a:xfrm>
            <a:off x="2461988" y="245903"/>
            <a:ext cx="8891195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2400" b="1" dirty="0">
                <a:solidFill>
                  <a:schemeClr val="accent6">
                    <a:lumMod val="75000"/>
                  </a:schemeClr>
                </a:solidFill>
                <a:effectLst/>
                <a:ea typeface="Times New Roman" panose="02020603050405020304" pitchFamily="18" charset="0"/>
              </a:rPr>
              <a:t>CLINICAL PATHWAY OF COVID-19 PATIENTS IN PRIMARY CARE IN 30 EUROPEAN COUNTRIES: EURODATA STUDY</a:t>
            </a:r>
            <a:r>
              <a:rPr lang="es-ES" sz="2400" dirty="0">
                <a:solidFill>
                  <a:schemeClr val="accent6">
                    <a:lumMod val="75000"/>
                  </a:schemeClr>
                </a:solidFill>
                <a:effectLst/>
              </a:rPr>
              <a:t> </a:t>
            </a:r>
            <a:endParaRPr lang="en-GB" sz="2400" dirty="0">
              <a:solidFill>
                <a:schemeClr val="accent6">
                  <a:lumMod val="75000"/>
                </a:schemeClr>
              </a:solidFill>
            </a:endParaRPr>
          </a:p>
        </p:txBody>
      </p:sp>
      <p:graphicFrame>
        <p:nvGraphicFramePr>
          <p:cNvPr id="23" name="Diagrama 22">
            <a:extLst>
              <a:ext uri="{FF2B5EF4-FFF2-40B4-BE49-F238E27FC236}">
                <a16:creationId xmlns:a16="http://schemas.microsoft.com/office/drawing/2014/main" id="{ED4096F0-DD1D-F334-2E36-FD3B83EB17EE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152683796"/>
              </p:ext>
            </p:extLst>
          </p:nvPr>
        </p:nvGraphicFramePr>
        <p:xfrm>
          <a:off x="1019882" y="-457201"/>
          <a:ext cx="10661425" cy="7315201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4" r:lo="rId5" r:qs="rId6" r:cs="rId7"/>
          </a:graphicData>
        </a:graphic>
      </p:graphicFrame>
      <p:sp>
        <p:nvSpPr>
          <p:cNvPr id="3" name="CuadroTexto 2">
            <a:extLst>
              <a:ext uri="{FF2B5EF4-FFF2-40B4-BE49-F238E27FC236}">
                <a16:creationId xmlns:a16="http://schemas.microsoft.com/office/drawing/2014/main" id="{793D44A0-3A51-F887-BB99-73CA7C2BB7D3}"/>
              </a:ext>
            </a:extLst>
          </p:cNvPr>
          <p:cNvSpPr txBox="1"/>
          <p:nvPr/>
        </p:nvSpPr>
        <p:spPr>
          <a:xfrm>
            <a:off x="1019883" y="5134769"/>
            <a:ext cx="106614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accent6">
                    <a:lumMod val="75000"/>
                  </a:schemeClr>
                </a:solidFill>
              </a:rPr>
              <a:t>Implications for practice</a:t>
            </a:r>
            <a:r>
              <a:rPr lang="en-GB" dirty="0"/>
              <a:t>: T</a:t>
            </a:r>
            <a:r>
              <a:rPr lang="en-GB" sz="1800" dirty="0">
                <a:effectLst/>
                <a:ea typeface="Times New Roman" panose="02020603050405020304" pitchFamily="18" charset="0"/>
              </a:rPr>
              <a:t>he burden of communicable disease outbreaks for primary care should be recognized, monitored and supported by additional resources</a:t>
            </a:r>
            <a:endParaRPr lang="en-GB" dirty="0"/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D5621AF4-A91B-2F10-E9EE-BB291DF5064F}"/>
              </a:ext>
            </a:extLst>
          </p:cNvPr>
          <p:cNvSpPr txBox="1"/>
          <p:nvPr/>
        </p:nvSpPr>
        <p:spPr>
          <a:xfrm>
            <a:off x="1" y="6191816"/>
            <a:ext cx="3314700" cy="800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solidFill>
                  <a:schemeClr val="accent6">
                    <a:lumMod val="75000"/>
                  </a:schemeClr>
                </a:solidFill>
              </a:rPr>
              <a:t>@</a:t>
            </a:r>
            <a:r>
              <a:rPr lang="en-GB" dirty="0" err="1">
                <a:solidFill>
                  <a:schemeClr val="accent6">
                    <a:lumMod val="75000"/>
                  </a:schemeClr>
                </a:solidFill>
              </a:rPr>
              <a:t>woncaeurope</a:t>
            </a:r>
            <a:r>
              <a:rPr lang="en-GB" dirty="0">
                <a:solidFill>
                  <a:schemeClr val="accent6">
                    <a:lumMod val="75000"/>
                  </a:schemeClr>
                </a:solidFill>
              </a:rPr>
              <a:t>  @</a:t>
            </a:r>
            <a:r>
              <a:rPr lang="es-ES" b="0" i="0" u="none" strike="noStrike" dirty="0" err="1">
                <a:solidFill>
                  <a:schemeClr val="accent6">
                    <a:lumMod val="75000"/>
                  </a:schemeClr>
                </a:solidFill>
                <a:effectLst/>
                <a:latin typeface="TwitterChirp"/>
              </a:rPr>
              <a:t>EurJGenPract</a:t>
            </a:r>
            <a:endParaRPr lang="es-ES" b="0" i="0" u="none" strike="noStrike" dirty="0">
              <a:solidFill>
                <a:schemeClr val="accent6">
                  <a:lumMod val="75000"/>
                </a:schemeClr>
              </a:solidFill>
              <a:effectLst/>
              <a:latin typeface="TwitterChirp"/>
            </a:endParaRPr>
          </a:p>
          <a:p>
            <a:pPr algn="ctr"/>
            <a:r>
              <a:rPr lang="es-ES" sz="1000" dirty="0" err="1">
                <a:solidFill>
                  <a:schemeClr val="accent6">
                    <a:lumMod val="75000"/>
                  </a:schemeClr>
                </a:solidFill>
                <a:latin typeface="TwitterChirp"/>
              </a:rPr>
              <a:t>Icons</a:t>
            </a:r>
            <a:r>
              <a:rPr lang="es-ES" sz="1000" dirty="0">
                <a:solidFill>
                  <a:schemeClr val="accent6">
                    <a:lumMod val="75000"/>
                  </a:schemeClr>
                </a:solidFill>
                <a:latin typeface="TwitterChirp"/>
              </a:rPr>
              <a:t>: @</a:t>
            </a:r>
            <a:r>
              <a:rPr lang="es-ES" sz="1000" dirty="0" err="1">
                <a:solidFill>
                  <a:schemeClr val="accent6">
                    <a:lumMod val="75000"/>
                  </a:schemeClr>
                </a:solidFill>
                <a:latin typeface="TwitterChirp"/>
              </a:rPr>
              <a:t>flaticon</a:t>
            </a:r>
            <a:r>
              <a:rPr lang="es-ES" sz="1000" dirty="0">
                <a:solidFill>
                  <a:schemeClr val="accent6">
                    <a:lumMod val="75000"/>
                  </a:schemeClr>
                </a:solidFill>
                <a:latin typeface="TwitterChirp"/>
              </a:rPr>
              <a:t> (</a:t>
            </a:r>
            <a:r>
              <a:rPr lang="es-ES" sz="1000" dirty="0" err="1">
                <a:solidFill>
                  <a:schemeClr val="accent6">
                    <a:lumMod val="75000"/>
                  </a:schemeClr>
                </a:solidFill>
                <a:latin typeface="TwitterChirp"/>
              </a:rPr>
              <a:t>Trazobanana</a:t>
            </a:r>
            <a:r>
              <a:rPr lang="es-ES" sz="1000" dirty="0">
                <a:solidFill>
                  <a:schemeClr val="accent6">
                    <a:lumMod val="75000"/>
                  </a:schemeClr>
                </a:solidFill>
                <a:latin typeface="TwitterChirp"/>
              </a:rPr>
              <a:t>, </a:t>
            </a:r>
            <a:r>
              <a:rPr lang="es-ES" sz="1000" dirty="0" err="1">
                <a:solidFill>
                  <a:schemeClr val="accent6">
                    <a:lumMod val="75000"/>
                  </a:schemeClr>
                </a:solidFill>
                <a:effectLst/>
                <a:latin typeface="Helvetica Neue" panose="02000503000000020004" pitchFamily="2" charset="0"/>
              </a:rPr>
              <a:t>Freepik</a:t>
            </a:r>
            <a:r>
              <a:rPr lang="es-ES" sz="1000" dirty="0">
                <a:solidFill>
                  <a:schemeClr val="accent6">
                    <a:lumMod val="75000"/>
                  </a:schemeClr>
                </a:solidFill>
                <a:latin typeface="TwitterChirp"/>
              </a:rPr>
              <a:t>)</a:t>
            </a:r>
          </a:p>
          <a:p>
            <a:endParaRPr lang="en-GB" dirty="0">
              <a:solidFill>
                <a:schemeClr val="accent6">
                  <a:lumMod val="75000"/>
                </a:schemeClr>
              </a:solidFill>
            </a:endParaRP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985DA82C-BF58-9644-7A42-BDFEAE72C8C4}"/>
              </a:ext>
            </a:extLst>
          </p:cNvPr>
          <p:cNvSpPr txBox="1"/>
          <p:nvPr/>
        </p:nvSpPr>
        <p:spPr>
          <a:xfrm>
            <a:off x="9244501" y="6242765"/>
            <a:ext cx="21086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chemeClr val="accent6">
                    <a:lumMod val="75000"/>
                  </a:schemeClr>
                </a:solidFill>
              </a:rPr>
              <a:t>Links EJGP</a:t>
            </a:r>
          </a:p>
        </p:txBody>
      </p:sp>
    </p:spTree>
    <p:extLst>
      <p:ext uri="{BB962C8B-B14F-4D97-AF65-F5344CB8AC3E}">
        <p14:creationId xmlns:p14="http://schemas.microsoft.com/office/powerpoint/2010/main" val="222401675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1</TotalTime>
  <Words>125</Words>
  <Application>Microsoft Macintosh PowerPoint</Application>
  <PresentationFormat>Panorámica</PresentationFormat>
  <Paragraphs>21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6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Helvetica Neue</vt:lpstr>
      <vt:lpstr>TwitterChirp</vt:lpstr>
      <vt:lpstr>Wingdings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Sara Ares Blanco</dc:creator>
  <cp:lastModifiedBy>Raquel Gomez Bravo</cp:lastModifiedBy>
  <cp:revision>5</cp:revision>
  <dcterms:created xsi:type="dcterms:W3CDTF">2023-02-02T15:58:16Z</dcterms:created>
  <dcterms:modified xsi:type="dcterms:W3CDTF">2023-02-03T15:44:51Z</dcterms:modified>
</cp:coreProperties>
</file>